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4212" y="1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ARLOS COSTAS INSUA" userId="e10c8832-4d3d-4782-833a-236983bbf7b2" providerId="ADAL" clId="{4B4A3358-5FE0-4809-BC81-23DEF2B1FD97}"/>
    <pc:docChg chg="undo custSel modSld">
      <pc:chgData name="CARLOS COSTAS INSUA" userId="e10c8832-4d3d-4782-833a-236983bbf7b2" providerId="ADAL" clId="{4B4A3358-5FE0-4809-BC81-23DEF2B1FD97}" dt="2024-01-21T14:32:08.407" v="536" actId="14100"/>
      <pc:docMkLst>
        <pc:docMk/>
      </pc:docMkLst>
      <pc:sldChg chg="addSp delSp modSp mod">
        <pc:chgData name="CARLOS COSTAS INSUA" userId="e10c8832-4d3d-4782-833a-236983bbf7b2" providerId="ADAL" clId="{4B4A3358-5FE0-4809-BC81-23DEF2B1FD97}" dt="2024-01-21T14:32:08.407" v="536" actId="14100"/>
        <pc:sldMkLst>
          <pc:docMk/>
          <pc:sldMk cId="2004873951" sldId="256"/>
        </pc:sldMkLst>
        <pc:spChg chg="add mod">
          <ac:chgData name="CARLOS COSTAS INSUA" userId="e10c8832-4d3d-4782-833a-236983bbf7b2" providerId="ADAL" clId="{4B4A3358-5FE0-4809-BC81-23DEF2B1FD97}" dt="2024-01-21T14:24:55.253" v="215" actId="1037"/>
          <ac:spMkLst>
            <pc:docMk/>
            <pc:sldMk cId="2004873951" sldId="256"/>
            <ac:spMk id="8" creationId="{C69446B8-A359-F682-A48C-0DC0733B0FA9}"/>
          </ac:spMkLst>
        </pc:spChg>
        <pc:spChg chg="add mod">
          <ac:chgData name="CARLOS COSTAS INSUA" userId="e10c8832-4d3d-4782-833a-236983bbf7b2" providerId="ADAL" clId="{4B4A3358-5FE0-4809-BC81-23DEF2B1FD97}" dt="2024-01-21T14:25:08.189" v="224" actId="1037"/>
          <ac:spMkLst>
            <pc:docMk/>
            <pc:sldMk cId="2004873951" sldId="256"/>
            <ac:spMk id="9" creationId="{9D1FEDA3-A3A5-E7BD-6DF5-DE63BD10FEEA}"/>
          </ac:spMkLst>
        </pc:spChg>
        <pc:spChg chg="add mod">
          <ac:chgData name="CARLOS COSTAS INSUA" userId="e10c8832-4d3d-4782-833a-236983bbf7b2" providerId="ADAL" clId="{4B4A3358-5FE0-4809-BC81-23DEF2B1FD97}" dt="2024-01-21T14:26:56.350" v="351" actId="1076"/>
          <ac:spMkLst>
            <pc:docMk/>
            <pc:sldMk cId="2004873951" sldId="256"/>
            <ac:spMk id="10" creationId="{91BFDDAA-DFBB-33D7-77DD-58FD0F3DCE32}"/>
          </ac:spMkLst>
        </pc:spChg>
        <pc:spChg chg="add mod">
          <ac:chgData name="CARLOS COSTAS INSUA" userId="e10c8832-4d3d-4782-833a-236983bbf7b2" providerId="ADAL" clId="{4B4A3358-5FE0-4809-BC81-23DEF2B1FD97}" dt="2024-01-21T14:28:08.047" v="403" actId="1076"/>
          <ac:spMkLst>
            <pc:docMk/>
            <pc:sldMk cId="2004873951" sldId="256"/>
            <ac:spMk id="11" creationId="{CC77F6DE-49D3-BD09-60CA-AF2571A7B226}"/>
          </ac:spMkLst>
        </pc:spChg>
        <pc:spChg chg="add mod">
          <ac:chgData name="CARLOS COSTAS INSUA" userId="e10c8832-4d3d-4782-833a-236983bbf7b2" providerId="ADAL" clId="{4B4A3358-5FE0-4809-BC81-23DEF2B1FD97}" dt="2024-01-21T14:29:14.048" v="437" actId="1037"/>
          <ac:spMkLst>
            <pc:docMk/>
            <pc:sldMk cId="2004873951" sldId="256"/>
            <ac:spMk id="12" creationId="{86ACA1E2-E2FB-B222-4450-6A8BDA2B11D3}"/>
          </ac:spMkLst>
        </pc:spChg>
        <pc:spChg chg="add mod">
          <ac:chgData name="CARLOS COSTAS INSUA" userId="e10c8832-4d3d-4782-833a-236983bbf7b2" providerId="ADAL" clId="{4B4A3358-5FE0-4809-BC81-23DEF2B1FD97}" dt="2024-01-21T14:30:11.071" v="465" actId="1038"/>
          <ac:spMkLst>
            <pc:docMk/>
            <pc:sldMk cId="2004873951" sldId="256"/>
            <ac:spMk id="13" creationId="{BF1E1E78-773F-282E-2DC5-CAFC6841AA30}"/>
          </ac:spMkLst>
        </pc:spChg>
        <pc:spChg chg="add mod">
          <ac:chgData name="CARLOS COSTAS INSUA" userId="e10c8832-4d3d-4782-833a-236983bbf7b2" providerId="ADAL" clId="{4B4A3358-5FE0-4809-BC81-23DEF2B1FD97}" dt="2024-01-21T14:31:01.390" v="501" actId="20577"/>
          <ac:spMkLst>
            <pc:docMk/>
            <pc:sldMk cId="2004873951" sldId="256"/>
            <ac:spMk id="14" creationId="{F7E0C3C2-7F16-6177-D8A6-E1CB5DECBF2B}"/>
          </ac:spMkLst>
        </pc:spChg>
        <pc:spChg chg="add mod">
          <ac:chgData name="CARLOS COSTAS INSUA" userId="e10c8832-4d3d-4782-833a-236983bbf7b2" providerId="ADAL" clId="{4B4A3358-5FE0-4809-BC81-23DEF2B1FD97}" dt="2024-01-21T14:32:08.407" v="536" actId="14100"/>
          <ac:spMkLst>
            <pc:docMk/>
            <pc:sldMk cId="2004873951" sldId="256"/>
            <ac:spMk id="15" creationId="{201CE3A1-200A-CC34-54A3-6FCE713C6956}"/>
          </ac:spMkLst>
        </pc:spChg>
        <pc:spChg chg="add mod">
          <ac:chgData name="CARLOS COSTAS INSUA" userId="e10c8832-4d3d-4782-833a-236983bbf7b2" providerId="ADAL" clId="{4B4A3358-5FE0-4809-BC81-23DEF2B1FD97}" dt="2024-01-21T14:31:44.615" v="524" actId="14100"/>
          <ac:spMkLst>
            <pc:docMk/>
            <pc:sldMk cId="2004873951" sldId="256"/>
            <ac:spMk id="16" creationId="{788656F0-61BE-04FF-BD32-022699997E24}"/>
          </ac:spMkLst>
        </pc:spChg>
        <pc:spChg chg="add mod">
          <ac:chgData name="CARLOS COSTAS INSUA" userId="e10c8832-4d3d-4782-833a-236983bbf7b2" providerId="ADAL" clId="{4B4A3358-5FE0-4809-BC81-23DEF2B1FD97}" dt="2024-01-21T14:31:29.243" v="513" actId="14100"/>
          <ac:spMkLst>
            <pc:docMk/>
            <pc:sldMk cId="2004873951" sldId="256"/>
            <ac:spMk id="17" creationId="{9F7127FD-A260-CD52-7A25-88480D36CE20}"/>
          </ac:spMkLst>
        </pc:spChg>
        <pc:spChg chg="mod topLvl">
          <ac:chgData name="CARLOS COSTAS INSUA" userId="e10c8832-4d3d-4782-833a-236983bbf7b2" providerId="ADAL" clId="{4B4A3358-5FE0-4809-BC81-23DEF2B1FD97}" dt="2024-01-21T14:23:05.471" v="162" actId="14100"/>
          <ac:spMkLst>
            <pc:docMk/>
            <pc:sldMk cId="2004873951" sldId="256"/>
            <ac:spMk id="1362" creationId="{A0D1A375-D2D6-FD4A-6775-D426EC941C6A}"/>
          </ac:spMkLst>
        </pc:spChg>
        <pc:spChg chg="mod">
          <ac:chgData name="CARLOS COSTAS INSUA" userId="e10c8832-4d3d-4782-833a-236983bbf7b2" providerId="ADAL" clId="{4B4A3358-5FE0-4809-BC81-23DEF2B1FD97}" dt="2024-01-21T14:31:57.941" v="535" actId="14100"/>
          <ac:spMkLst>
            <pc:docMk/>
            <pc:sldMk cId="2004873951" sldId="256"/>
            <ac:spMk id="1754" creationId="{05907BE4-EAE5-6026-200F-8E7E984B2864}"/>
          </ac:spMkLst>
        </pc:spChg>
        <pc:spChg chg="del mod topLvl">
          <ac:chgData name="CARLOS COSTAS INSUA" userId="e10c8832-4d3d-4782-833a-236983bbf7b2" providerId="ADAL" clId="{4B4A3358-5FE0-4809-BC81-23DEF2B1FD97}" dt="2024-01-21T14:25:00.831" v="217" actId="478"/>
          <ac:spMkLst>
            <pc:docMk/>
            <pc:sldMk cId="2004873951" sldId="256"/>
            <ac:spMk id="2547" creationId="{038B4F6E-AE7C-81EF-9B70-206B249496C9}"/>
          </ac:spMkLst>
        </pc:spChg>
        <pc:spChg chg="del mod topLvl">
          <ac:chgData name="CARLOS COSTAS INSUA" userId="e10c8832-4d3d-4782-833a-236983bbf7b2" providerId="ADAL" clId="{4B4A3358-5FE0-4809-BC81-23DEF2B1FD97}" dt="2024-01-21T14:24:39.396" v="208" actId="478"/>
          <ac:spMkLst>
            <pc:docMk/>
            <pc:sldMk cId="2004873951" sldId="256"/>
            <ac:spMk id="2549" creationId="{02083E3C-1DC7-91D7-3870-E148BEA7D4D4}"/>
          </ac:spMkLst>
        </pc:spChg>
        <pc:spChg chg="mod topLvl">
          <ac:chgData name="CARLOS COSTAS INSUA" userId="e10c8832-4d3d-4782-833a-236983bbf7b2" providerId="ADAL" clId="{4B4A3358-5FE0-4809-BC81-23DEF2B1FD97}" dt="2024-01-21T14:25:50.699" v="284" actId="20577"/>
          <ac:spMkLst>
            <pc:docMk/>
            <pc:sldMk cId="2004873951" sldId="256"/>
            <ac:spMk id="2553" creationId="{75DAD5D6-EE9B-3F86-4DB1-13AFD23F71BE}"/>
          </ac:spMkLst>
        </pc:spChg>
        <pc:spChg chg="mod">
          <ac:chgData name="CARLOS COSTAS INSUA" userId="e10c8832-4d3d-4782-833a-236983bbf7b2" providerId="ADAL" clId="{4B4A3358-5FE0-4809-BC81-23DEF2B1FD97}" dt="2024-01-21T14:25:32.528" v="268" actId="1036"/>
          <ac:spMkLst>
            <pc:docMk/>
            <pc:sldMk cId="2004873951" sldId="256"/>
            <ac:spMk id="2554" creationId="{B0CF2F16-ED7E-E99E-EFF7-B0615AC4E336}"/>
          </ac:spMkLst>
        </pc:spChg>
        <pc:spChg chg="mod">
          <ac:chgData name="CARLOS COSTAS INSUA" userId="e10c8832-4d3d-4782-833a-236983bbf7b2" providerId="ADAL" clId="{4B4A3358-5FE0-4809-BC81-23DEF2B1FD97}" dt="2024-01-21T14:25:35.982" v="271" actId="1035"/>
          <ac:spMkLst>
            <pc:docMk/>
            <pc:sldMk cId="2004873951" sldId="256"/>
            <ac:spMk id="2555" creationId="{743B99BA-D5E8-8BE3-28D3-1D1C7A4119F3}"/>
          </ac:spMkLst>
        </pc:spChg>
        <pc:spChg chg="mod">
          <ac:chgData name="CARLOS COSTAS INSUA" userId="e10c8832-4d3d-4782-833a-236983bbf7b2" providerId="ADAL" clId="{4B4A3358-5FE0-4809-BC81-23DEF2B1FD97}" dt="2024-01-21T14:20:34.044" v="12" actId="165"/>
          <ac:spMkLst>
            <pc:docMk/>
            <pc:sldMk cId="2004873951" sldId="256"/>
            <ac:spMk id="2556" creationId="{A934634D-990D-C344-A2A4-F1B6656D0C5D}"/>
          </ac:spMkLst>
        </pc:spChg>
        <pc:spChg chg="mod topLvl">
          <ac:chgData name="CARLOS COSTAS INSUA" userId="e10c8832-4d3d-4782-833a-236983bbf7b2" providerId="ADAL" clId="{4B4A3358-5FE0-4809-BC81-23DEF2B1FD97}" dt="2024-01-21T14:25:15.422" v="245" actId="1037"/>
          <ac:spMkLst>
            <pc:docMk/>
            <pc:sldMk cId="2004873951" sldId="256"/>
            <ac:spMk id="2562" creationId="{964DE709-22DD-7CB7-AB8A-93AA6455A50E}"/>
          </ac:spMkLst>
        </pc:spChg>
        <pc:spChg chg="mod topLvl">
          <ac:chgData name="CARLOS COSTAS INSUA" userId="e10c8832-4d3d-4782-833a-236983bbf7b2" providerId="ADAL" clId="{4B4A3358-5FE0-4809-BC81-23DEF2B1FD97}" dt="2024-01-21T14:22:48.115" v="141" actId="1038"/>
          <ac:spMkLst>
            <pc:docMk/>
            <pc:sldMk cId="2004873951" sldId="256"/>
            <ac:spMk id="2566" creationId="{186620A4-910C-F2F2-E1C8-015FF2EF112A}"/>
          </ac:spMkLst>
        </pc:spChg>
        <pc:spChg chg="mod">
          <ac:chgData name="CARLOS COSTAS INSUA" userId="e10c8832-4d3d-4782-833a-236983bbf7b2" providerId="ADAL" clId="{4B4A3358-5FE0-4809-BC81-23DEF2B1FD97}" dt="2024-01-21T14:20:34.044" v="12" actId="165"/>
          <ac:spMkLst>
            <pc:docMk/>
            <pc:sldMk cId="2004873951" sldId="256"/>
            <ac:spMk id="2567" creationId="{CF7D08F4-A638-CA13-4285-D0CEBB3F35E1}"/>
          </ac:spMkLst>
        </pc:spChg>
        <pc:spChg chg="mod">
          <ac:chgData name="CARLOS COSTAS INSUA" userId="e10c8832-4d3d-4782-833a-236983bbf7b2" providerId="ADAL" clId="{4B4A3358-5FE0-4809-BC81-23DEF2B1FD97}" dt="2024-01-21T14:20:34.044" v="12" actId="165"/>
          <ac:spMkLst>
            <pc:docMk/>
            <pc:sldMk cId="2004873951" sldId="256"/>
            <ac:spMk id="2568" creationId="{292FE5CD-44B9-9B72-C209-7E2E81FABDD3}"/>
          </ac:spMkLst>
        </pc:spChg>
        <pc:spChg chg="mod">
          <ac:chgData name="CARLOS COSTAS INSUA" userId="e10c8832-4d3d-4782-833a-236983bbf7b2" providerId="ADAL" clId="{4B4A3358-5FE0-4809-BC81-23DEF2B1FD97}" dt="2024-01-21T14:20:34.044" v="12" actId="165"/>
          <ac:spMkLst>
            <pc:docMk/>
            <pc:sldMk cId="2004873951" sldId="256"/>
            <ac:spMk id="2569" creationId="{84C7EB1B-7D89-7097-0E6C-D538858D6079}"/>
          </ac:spMkLst>
        </pc:spChg>
        <pc:spChg chg="mod topLvl">
          <ac:chgData name="CARLOS COSTAS INSUA" userId="e10c8832-4d3d-4782-833a-236983bbf7b2" providerId="ADAL" clId="{4B4A3358-5FE0-4809-BC81-23DEF2B1FD97}" dt="2024-01-21T14:26:42.732" v="330" actId="1037"/>
          <ac:spMkLst>
            <pc:docMk/>
            <pc:sldMk cId="2004873951" sldId="256"/>
            <ac:spMk id="2588" creationId="{2AAFC5FB-03C2-A03D-D872-95BAC81D0E90}"/>
          </ac:spMkLst>
        </pc:spChg>
        <pc:spChg chg="mod">
          <ac:chgData name="CARLOS COSTAS INSUA" userId="e10c8832-4d3d-4782-833a-236983bbf7b2" providerId="ADAL" clId="{4B4A3358-5FE0-4809-BC81-23DEF2B1FD97}" dt="2024-01-21T14:20:34.044" v="12" actId="165"/>
          <ac:spMkLst>
            <pc:docMk/>
            <pc:sldMk cId="2004873951" sldId="256"/>
            <ac:spMk id="2589" creationId="{69A5F5F9-9909-4AB1-673B-F17ADE2D31E0}"/>
          </ac:spMkLst>
        </pc:spChg>
        <pc:spChg chg="mod">
          <ac:chgData name="CARLOS COSTAS INSUA" userId="e10c8832-4d3d-4782-833a-236983bbf7b2" providerId="ADAL" clId="{4B4A3358-5FE0-4809-BC81-23DEF2B1FD97}" dt="2024-01-21T14:20:34.044" v="12" actId="165"/>
          <ac:spMkLst>
            <pc:docMk/>
            <pc:sldMk cId="2004873951" sldId="256"/>
            <ac:spMk id="2590" creationId="{955C66DD-20B7-16F6-92C6-50BF1E41AE2A}"/>
          </ac:spMkLst>
        </pc:spChg>
        <pc:spChg chg="mod">
          <ac:chgData name="CARLOS COSTAS INSUA" userId="e10c8832-4d3d-4782-833a-236983bbf7b2" providerId="ADAL" clId="{4B4A3358-5FE0-4809-BC81-23DEF2B1FD97}" dt="2024-01-21T14:20:34.044" v="12" actId="165"/>
          <ac:spMkLst>
            <pc:docMk/>
            <pc:sldMk cId="2004873951" sldId="256"/>
            <ac:spMk id="2591" creationId="{E8142825-92D4-605B-0680-E449FD1DEFD4}"/>
          </ac:spMkLst>
        </pc:spChg>
        <pc:spChg chg="del mod topLvl">
          <ac:chgData name="CARLOS COSTAS INSUA" userId="e10c8832-4d3d-4782-833a-236983bbf7b2" providerId="ADAL" clId="{4B4A3358-5FE0-4809-BC81-23DEF2B1FD97}" dt="2024-01-21T14:26:30.575" v="295" actId="478"/>
          <ac:spMkLst>
            <pc:docMk/>
            <pc:sldMk cId="2004873951" sldId="256"/>
            <ac:spMk id="2595" creationId="{195849F1-B1C1-529B-BDD8-228619FBCA2A}"/>
          </ac:spMkLst>
        </pc:spChg>
        <pc:spChg chg="del mod topLvl">
          <ac:chgData name="CARLOS COSTAS INSUA" userId="e10c8832-4d3d-4782-833a-236983bbf7b2" providerId="ADAL" clId="{4B4A3358-5FE0-4809-BC81-23DEF2B1FD97}" dt="2024-01-21T14:30:33.740" v="471" actId="478"/>
          <ac:spMkLst>
            <pc:docMk/>
            <pc:sldMk cId="2004873951" sldId="256"/>
            <ac:spMk id="2596" creationId="{3C216ABE-A851-E86F-B037-6EB1E7CEFF39}"/>
          </ac:spMkLst>
        </pc:spChg>
        <pc:spChg chg="del mod topLvl">
          <ac:chgData name="CARLOS COSTAS INSUA" userId="e10c8832-4d3d-4782-833a-236983bbf7b2" providerId="ADAL" clId="{4B4A3358-5FE0-4809-BC81-23DEF2B1FD97}" dt="2024-01-21T14:31:18.699" v="508" actId="478"/>
          <ac:spMkLst>
            <pc:docMk/>
            <pc:sldMk cId="2004873951" sldId="256"/>
            <ac:spMk id="2597" creationId="{DA76FD5F-F405-DC69-14A8-32184A7CB30A}"/>
          </ac:spMkLst>
        </pc:spChg>
        <pc:spChg chg="del mod topLvl">
          <ac:chgData name="CARLOS COSTAS INSUA" userId="e10c8832-4d3d-4782-833a-236983bbf7b2" providerId="ADAL" clId="{4B4A3358-5FE0-4809-BC81-23DEF2B1FD97}" dt="2024-01-21T14:27:58.221" v="400" actId="478"/>
          <ac:spMkLst>
            <pc:docMk/>
            <pc:sldMk cId="2004873951" sldId="256"/>
            <ac:spMk id="2598" creationId="{F50718BB-89B3-97AB-C202-F68A6539B4FB}"/>
          </ac:spMkLst>
        </pc:spChg>
        <pc:spChg chg="mod topLvl">
          <ac:chgData name="CARLOS COSTAS INSUA" userId="e10c8832-4d3d-4782-833a-236983bbf7b2" providerId="ADAL" clId="{4B4A3358-5FE0-4809-BC81-23DEF2B1FD97}" dt="2024-01-21T14:27:55.268" v="399" actId="1038"/>
          <ac:spMkLst>
            <pc:docMk/>
            <pc:sldMk cId="2004873951" sldId="256"/>
            <ac:spMk id="2601" creationId="{4418FFC3-B8DE-F623-2C47-DD22285BFE76}"/>
          </ac:spMkLst>
        </pc:spChg>
        <pc:spChg chg="mod">
          <ac:chgData name="CARLOS COSTAS INSUA" userId="e10c8832-4d3d-4782-833a-236983bbf7b2" providerId="ADAL" clId="{4B4A3358-5FE0-4809-BC81-23DEF2B1FD97}" dt="2024-01-21T14:20:34.044" v="12" actId="165"/>
          <ac:spMkLst>
            <pc:docMk/>
            <pc:sldMk cId="2004873951" sldId="256"/>
            <ac:spMk id="2602" creationId="{EF303AF1-73D3-D6EB-0E0D-E489EE393CD9}"/>
          </ac:spMkLst>
        </pc:spChg>
        <pc:spChg chg="mod">
          <ac:chgData name="CARLOS COSTAS INSUA" userId="e10c8832-4d3d-4782-833a-236983bbf7b2" providerId="ADAL" clId="{4B4A3358-5FE0-4809-BC81-23DEF2B1FD97}" dt="2024-01-21T14:20:34.044" v="12" actId="165"/>
          <ac:spMkLst>
            <pc:docMk/>
            <pc:sldMk cId="2004873951" sldId="256"/>
            <ac:spMk id="2603" creationId="{3121C709-7B7F-F4EA-2408-BDE4B9D21036}"/>
          </ac:spMkLst>
        </pc:spChg>
        <pc:spChg chg="mod">
          <ac:chgData name="CARLOS COSTAS INSUA" userId="e10c8832-4d3d-4782-833a-236983bbf7b2" providerId="ADAL" clId="{4B4A3358-5FE0-4809-BC81-23DEF2B1FD97}" dt="2024-01-21T14:20:34.044" v="12" actId="165"/>
          <ac:spMkLst>
            <pc:docMk/>
            <pc:sldMk cId="2004873951" sldId="256"/>
            <ac:spMk id="2604" creationId="{8AC20314-E187-32DF-9C4C-D8A97241CBBE}"/>
          </ac:spMkLst>
        </pc:spChg>
        <pc:spChg chg="del mod topLvl">
          <ac:chgData name="CARLOS COSTAS INSUA" userId="e10c8832-4d3d-4782-833a-236983bbf7b2" providerId="ADAL" clId="{4B4A3358-5FE0-4809-BC81-23DEF2B1FD97}" dt="2024-01-21T14:29:05.003" v="432" actId="478"/>
          <ac:spMkLst>
            <pc:docMk/>
            <pc:sldMk cId="2004873951" sldId="256"/>
            <ac:spMk id="2605" creationId="{96AAE413-4AA5-AC33-BFA5-08810E1D7620}"/>
          </ac:spMkLst>
        </pc:spChg>
        <pc:spChg chg="del mod topLvl">
          <ac:chgData name="CARLOS COSTAS INSUA" userId="e10c8832-4d3d-4782-833a-236983bbf7b2" providerId="ADAL" clId="{4B4A3358-5FE0-4809-BC81-23DEF2B1FD97}" dt="2024-01-21T14:29:48.043" v="446" actId="478"/>
          <ac:spMkLst>
            <pc:docMk/>
            <pc:sldMk cId="2004873951" sldId="256"/>
            <ac:spMk id="2606" creationId="{89C092FB-9971-36EC-498E-8E1F3C62B4CF}"/>
          </ac:spMkLst>
        </pc:spChg>
        <pc:spChg chg="mod topLvl">
          <ac:chgData name="CARLOS COSTAS INSUA" userId="e10c8832-4d3d-4782-833a-236983bbf7b2" providerId="ADAL" clId="{4B4A3358-5FE0-4809-BC81-23DEF2B1FD97}" dt="2024-01-21T14:23:54.949" v="196" actId="1036"/>
          <ac:spMkLst>
            <pc:docMk/>
            <pc:sldMk cId="2004873951" sldId="256"/>
            <ac:spMk id="2609" creationId="{61BE3052-B485-1610-03AF-A1995B48DCFF}"/>
          </ac:spMkLst>
        </pc:spChg>
        <pc:spChg chg="mod">
          <ac:chgData name="CARLOS COSTAS INSUA" userId="e10c8832-4d3d-4782-833a-236983bbf7b2" providerId="ADAL" clId="{4B4A3358-5FE0-4809-BC81-23DEF2B1FD97}" dt="2024-01-21T14:20:34.044" v="12" actId="165"/>
          <ac:spMkLst>
            <pc:docMk/>
            <pc:sldMk cId="2004873951" sldId="256"/>
            <ac:spMk id="2610" creationId="{A3641947-9787-BE43-AFBD-16700B391F8E}"/>
          </ac:spMkLst>
        </pc:spChg>
        <pc:spChg chg="mod">
          <ac:chgData name="CARLOS COSTAS INSUA" userId="e10c8832-4d3d-4782-833a-236983bbf7b2" providerId="ADAL" clId="{4B4A3358-5FE0-4809-BC81-23DEF2B1FD97}" dt="2024-01-21T14:20:34.044" v="12" actId="165"/>
          <ac:spMkLst>
            <pc:docMk/>
            <pc:sldMk cId="2004873951" sldId="256"/>
            <ac:spMk id="2611" creationId="{7C81E3A2-3E7B-236D-46BE-7458C8A58072}"/>
          </ac:spMkLst>
        </pc:spChg>
        <pc:spChg chg="mod">
          <ac:chgData name="CARLOS COSTAS INSUA" userId="e10c8832-4d3d-4782-833a-236983bbf7b2" providerId="ADAL" clId="{4B4A3358-5FE0-4809-BC81-23DEF2B1FD97}" dt="2024-01-21T14:20:34.044" v="12" actId="165"/>
          <ac:spMkLst>
            <pc:docMk/>
            <pc:sldMk cId="2004873951" sldId="256"/>
            <ac:spMk id="2612" creationId="{5BDCF062-D6CD-D9B2-0D34-4F419E6C1456}"/>
          </ac:spMkLst>
        </pc:spChg>
        <pc:spChg chg="mod topLvl">
          <ac:chgData name="CARLOS COSTAS INSUA" userId="e10c8832-4d3d-4782-833a-236983bbf7b2" providerId="ADAL" clId="{4B4A3358-5FE0-4809-BC81-23DEF2B1FD97}" dt="2024-01-21T14:23:54.949" v="196" actId="1036"/>
          <ac:spMkLst>
            <pc:docMk/>
            <pc:sldMk cId="2004873951" sldId="256"/>
            <ac:spMk id="2615" creationId="{8420F2A8-9368-712C-2784-E38B3B313787}"/>
          </ac:spMkLst>
        </pc:spChg>
        <pc:spChg chg="mod">
          <ac:chgData name="CARLOS COSTAS INSUA" userId="e10c8832-4d3d-4782-833a-236983bbf7b2" providerId="ADAL" clId="{4B4A3358-5FE0-4809-BC81-23DEF2B1FD97}" dt="2024-01-21T14:20:34.044" v="12" actId="165"/>
          <ac:spMkLst>
            <pc:docMk/>
            <pc:sldMk cId="2004873951" sldId="256"/>
            <ac:spMk id="2616" creationId="{DFC6E288-8BA8-CCD2-4FD7-51A15F2A9102}"/>
          </ac:spMkLst>
        </pc:spChg>
        <pc:spChg chg="mod">
          <ac:chgData name="CARLOS COSTAS INSUA" userId="e10c8832-4d3d-4782-833a-236983bbf7b2" providerId="ADAL" clId="{4B4A3358-5FE0-4809-BC81-23DEF2B1FD97}" dt="2024-01-21T14:20:34.044" v="12" actId="165"/>
          <ac:spMkLst>
            <pc:docMk/>
            <pc:sldMk cId="2004873951" sldId="256"/>
            <ac:spMk id="2617" creationId="{D7B62601-EA4D-2D38-EF19-DEF6655CF8AB}"/>
          </ac:spMkLst>
        </pc:spChg>
        <pc:spChg chg="mod">
          <ac:chgData name="CARLOS COSTAS INSUA" userId="e10c8832-4d3d-4782-833a-236983bbf7b2" providerId="ADAL" clId="{4B4A3358-5FE0-4809-BC81-23DEF2B1FD97}" dt="2024-01-21T14:20:34.044" v="12" actId="165"/>
          <ac:spMkLst>
            <pc:docMk/>
            <pc:sldMk cId="2004873951" sldId="256"/>
            <ac:spMk id="2618" creationId="{8077C167-0E79-3690-66C1-BBF75698FD6F}"/>
          </ac:spMkLst>
        </pc:spChg>
        <pc:spChg chg="del mod topLvl">
          <ac:chgData name="CARLOS COSTAS INSUA" userId="e10c8832-4d3d-4782-833a-236983bbf7b2" providerId="ADAL" clId="{4B4A3358-5FE0-4809-BC81-23DEF2B1FD97}" dt="2024-01-21T14:30:54.220" v="492" actId="478"/>
          <ac:spMkLst>
            <pc:docMk/>
            <pc:sldMk cId="2004873951" sldId="256"/>
            <ac:spMk id="2619" creationId="{A4B7E94F-C2E5-3139-922C-4566DE95CDA0}"/>
          </ac:spMkLst>
        </pc:spChg>
        <pc:spChg chg="del mod topLvl">
          <ac:chgData name="CARLOS COSTAS INSUA" userId="e10c8832-4d3d-4782-833a-236983bbf7b2" providerId="ADAL" clId="{4B4A3358-5FE0-4809-BC81-23DEF2B1FD97}" dt="2024-01-21T14:31:37.632" v="516" actId="478"/>
          <ac:spMkLst>
            <pc:docMk/>
            <pc:sldMk cId="2004873951" sldId="256"/>
            <ac:spMk id="2620" creationId="{0A7CE3A5-1640-E845-5B26-7768DC5E5F67}"/>
          </ac:spMkLst>
        </pc:spChg>
        <pc:spChg chg="del">
          <ac:chgData name="CARLOS COSTAS INSUA" userId="e10c8832-4d3d-4782-833a-236983bbf7b2" providerId="ADAL" clId="{4B4A3358-5FE0-4809-BC81-23DEF2B1FD97}" dt="2024-01-21T14:19:26.958" v="0" actId="478"/>
          <ac:spMkLst>
            <pc:docMk/>
            <pc:sldMk cId="2004873951" sldId="256"/>
            <ac:spMk id="2630" creationId="{7AF5EF7A-B7E8-F2F8-551F-4FEE4E02024D}"/>
          </ac:spMkLst>
        </pc:spChg>
        <pc:spChg chg="del">
          <ac:chgData name="CARLOS COSTAS INSUA" userId="e10c8832-4d3d-4782-833a-236983bbf7b2" providerId="ADAL" clId="{4B4A3358-5FE0-4809-BC81-23DEF2B1FD97}" dt="2024-01-21T14:19:26.958" v="0" actId="478"/>
          <ac:spMkLst>
            <pc:docMk/>
            <pc:sldMk cId="2004873951" sldId="256"/>
            <ac:spMk id="2631" creationId="{55BF0729-F50B-5644-68AE-30A7EF4C6AFB}"/>
          </ac:spMkLst>
        </pc:spChg>
        <pc:spChg chg="del">
          <ac:chgData name="CARLOS COSTAS INSUA" userId="e10c8832-4d3d-4782-833a-236983bbf7b2" providerId="ADAL" clId="{4B4A3358-5FE0-4809-BC81-23DEF2B1FD97}" dt="2024-01-21T14:19:26.958" v="0" actId="478"/>
          <ac:spMkLst>
            <pc:docMk/>
            <pc:sldMk cId="2004873951" sldId="256"/>
            <ac:spMk id="2643" creationId="{F704E449-5841-C614-C262-A7216F1A08F7}"/>
          </ac:spMkLst>
        </pc:spChg>
        <pc:spChg chg="del">
          <ac:chgData name="CARLOS COSTAS INSUA" userId="e10c8832-4d3d-4782-833a-236983bbf7b2" providerId="ADAL" clId="{4B4A3358-5FE0-4809-BC81-23DEF2B1FD97}" dt="2024-01-21T14:19:26.958" v="0" actId="478"/>
          <ac:spMkLst>
            <pc:docMk/>
            <pc:sldMk cId="2004873951" sldId="256"/>
            <ac:spMk id="2653" creationId="{D56B2F0B-2A7E-995E-138F-2BF6E63A4100}"/>
          </ac:spMkLst>
        </pc:spChg>
        <pc:spChg chg="del">
          <ac:chgData name="CARLOS COSTAS INSUA" userId="e10c8832-4d3d-4782-833a-236983bbf7b2" providerId="ADAL" clId="{4B4A3358-5FE0-4809-BC81-23DEF2B1FD97}" dt="2024-01-21T14:19:26.958" v="0" actId="478"/>
          <ac:spMkLst>
            <pc:docMk/>
            <pc:sldMk cId="2004873951" sldId="256"/>
            <ac:spMk id="2654" creationId="{DB6799C3-8D22-C5B2-5635-1E5C1C108CDD}"/>
          </ac:spMkLst>
        </pc:spChg>
        <pc:spChg chg="del">
          <ac:chgData name="CARLOS COSTAS INSUA" userId="e10c8832-4d3d-4782-833a-236983bbf7b2" providerId="ADAL" clId="{4B4A3358-5FE0-4809-BC81-23DEF2B1FD97}" dt="2024-01-21T14:19:26.958" v="0" actId="478"/>
          <ac:spMkLst>
            <pc:docMk/>
            <pc:sldMk cId="2004873951" sldId="256"/>
            <ac:spMk id="2657" creationId="{467BB8CB-B100-B73B-BC40-634A016026B9}"/>
          </ac:spMkLst>
        </pc:spChg>
        <pc:spChg chg="del">
          <ac:chgData name="CARLOS COSTAS INSUA" userId="e10c8832-4d3d-4782-833a-236983bbf7b2" providerId="ADAL" clId="{4B4A3358-5FE0-4809-BC81-23DEF2B1FD97}" dt="2024-01-21T14:19:26.958" v="0" actId="478"/>
          <ac:spMkLst>
            <pc:docMk/>
            <pc:sldMk cId="2004873951" sldId="256"/>
            <ac:spMk id="2658" creationId="{2703FBF5-8FC8-D315-7B05-3E66DD813E97}"/>
          </ac:spMkLst>
        </pc:spChg>
        <pc:spChg chg="del">
          <ac:chgData name="CARLOS COSTAS INSUA" userId="e10c8832-4d3d-4782-833a-236983bbf7b2" providerId="ADAL" clId="{4B4A3358-5FE0-4809-BC81-23DEF2B1FD97}" dt="2024-01-21T14:19:26.958" v="0" actId="478"/>
          <ac:spMkLst>
            <pc:docMk/>
            <pc:sldMk cId="2004873951" sldId="256"/>
            <ac:spMk id="2662" creationId="{496CC556-1278-9AC9-472E-1476C805A056}"/>
          </ac:spMkLst>
        </pc:spChg>
        <pc:spChg chg="del">
          <ac:chgData name="CARLOS COSTAS INSUA" userId="e10c8832-4d3d-4782-833a-236983bbf7b2" providerId="ADAL" clId="{4B4A3358-5FE0-4809-BC81-23DEF2B1FD97}" dt="2024-01-21T14:19:26.958" v="0" actId="478"/>
          <ac:spMkLst>
            <pc:docMk/>
            <pc:sldMk cId="2004873951" sldId="256"/>
            <ac:spMk id="2672" creationId="{C6A3D622-EAFD-E2A1-76CC-DD713B6EED42}"/>
          </ac:spMkLst>
        </pc:spChg>
        <pc:spChg chg="del">
          <ac:chgData name="CARLOS COSTAS INSUA" userId="e10c8832-4d3d-4782-833a-236983bbf7b2" providerId="ADAL" clId="{4B4A3358-5FE0-4809-BC81-23DEF2B1FD97}" dt="2024-01-21T14:19:26.958" v="0" actId="478"/>
          <ac:spMkLst>
            <pc:docMk/>
            <pc:sldMk cId="2004873951" sldId="256"/>
            <ac:spMk id="2673" creationId="{1872F854-537C-B2E0-2857-CCA61A30A3D3}"/>
          </ac:spMkLst>
        </pc:spChg>
        <pc:spChg chg="del">
          <ac:chgData name="CARLOS COSTAS INSUA" userId="e10c8832-4d3d-4782-833a-236983bbf7b2" providerId="ADAL" clId="{4B4A3358-5FE0-4809-BC81-23DEF2B1FD97}" dt="2024-01-21T14:19:26.958" v="0" actId="478"/>
          <ac:spMkLst>
            <pc:docMk/>
            <pc:sldMk cId="2004873951" sldId="256"/>
            <ac:spMk id="2675" creationId="{87D140AC-5D34-F7A8-413B-1ECCACFD9F92}"/>
          </ac:spMkLst>
        </pc:spChg>
        <pc:spChg chg="del">
          <ac:chgData name="CARLOS COSTAS INSUA" userId="e10c8832-4d3d-4782-833a-236983bbf7b2" providerId="ADAL" clId="{4B4A3358-5FE0-4809-BC81-23DEF2B1FD97}" dt="2024-01-21T14:19:26.958" v="0" actId="478"/>
          <ac:spMkLst>
            <pc:docMk/>
            <pc:sldMk cId="2004873951" sldId="256"/>
            <ac:spMk id="2676" creationId="{C0350B31-1C1B-55D4-7F27-1FDF39AC80E8}"/>
          </ac:spMkLst>
        </pc:spChg>
        <pc:spChg chg="del">
          <ac:chgData name="CARLOS COSTAS INSUA" userId="e10c8832-4d3d-4782-833a-236983bbf7b2" providerId="ADAL" clId="{4B4A3358-5FE0-4809-BC81-23DEF2B1FD97}" dt="2024-01-21T14:19:26.958" v="0" actId="478"/>
          <ac:spMkLst>
            <pc:docMk/>
            <pc:sldMk cId="2004873951" sldId="256"/>
            <ac:spMk id="2691" creationId="{6F0CD617-F9A6-BF04-350C-916F13AFD145}"/>
          </ac:spMkLst>
        </pc:spChg>
        <pc:spChg chg="del">
          <ac:chgData name="CARLOS COSTAS INSUA" userId="e10c8832-4d3d-4782-833a-236983bbf7b2" providerId="ADAL" clId="{4B4A3358-5FE0-4809-BC81-23DEF2B1FD97}" dt="2024-01-21T14:19:26.958" v="0" actId="478"/>
          <ac:spMkLst>
            <pc:docMk/>
            <pc:sldMk cId="2004873951" sldId="256"/>
            <ac:spMk id="2692" creationId="{FB4B3A03-BA5B-9E21-B851-F9BAD7D5260F}"/>
          </ac:spMkLst>
        </pc:spChg>
        <pc:grpChg chg="del mod topLvl">
          <ac:chgData name="CARLOS COSTAS INSUA" userId="e10c8832-4d3d-4782-833a-236983bbf7b2" providerId="ADAL" clId="{4B4A3358-5FE0-4809-BC81-23DEF2B1FD97}" dt="2024-01-21T14:20:34.044" v="12" actId="165"/>
          <ac:grpSpMkLst>
            <pc:docMk/>
            <pc:sldMk cId="2004873951" sldId="256"/>
            <ac:grpSpMk id="2550" creationId="{FC84AB11-72A4-EE3C-BB97-20FBA4D091D3}"/>
          </ac:grpSpMkLst>
        </pc:grpChg>
        <pc:grpChg chg="del mod topLvl">
          <ac:chgData name="CARLOS COSTAS INSUA" userId="e10c8832-4d3d-4782-833a-236983bbf7b2" providerId="ADAL" clId="{4B4A3358-5FE0-4809-BC81-23DEF2B1FD97}" dt="2024-01-21T14:20:34.044" v="12" actId="165"/>
          <ac:grpSpMkLst>
            <pc:docMk/>
            <pc:sldMk cId="2004873951" sldId="256"/>
            <ac:grpSpMk id="2551" creationId="{7B5CDF60-EF4A-5A38-2538-3D415957573B}"/>
          </ac:grpSpMkLst>
        </pc:grpChg>
        <pc:grpChg chg="mod topLvl">
          <ac:chgData name="CARLOS COSTAS INSUA" userId="e10c8832-4d3d-4782-833a-236983bbf7b2" providerId="ADAL" clId="{4B4A3358-5FE0-4809-BC81-23DEF2B1FD97}" dt="2024-01-21T14:25:27.935" v="255" actId="1035"/>
          <ac:grpSpMkLst>
            <pc:docMk/>
            <pc:sldMk cId="2004873951" sldId="256"/>
            <ac:grpSpMk id="2557" creationId="{85D37F30-EFB2-3857-7DD5-F7FA8A37B3E0}"/>
          </ac:grpSpMkLst>
        </pc:grpChg>
        <pc:grpChg chg="del mod topLvl">
          <ac:chgData name="CARLOS COSTAS INSUA" userId="e10c8832-4d3d-4782-833a-236983bbf7b2" providerId="ADAL" clId="{4B4A3358-5FE0-4809-BC81-23DEF2B1FD97}" dt="2024-01-21T14:20:34.044" v="12" actId="165"/>
          <ac:grpSpMkLst>
            <pc:docMk/>
            <pc:sldMk cId="2004873951" sldId="256"/>
            <ac:grpSpMk id="2563" creationId="{FF171540-32FD-1AC3-2370-E210FB1176C4}"/>
          </ac:grpSpMkLst>
        </pc:grpChg>
        <pc:grpChg chg="del mod topLvl">
          <ac:chgData name="CARLOS COSTAS INSUA" userId="e10c8832-4d3d-4782-833a-236983bbf7b2" providerId="ADAL" clId="{4B4A3358-5FE0-4809-BC81-23DEF2B1FD97}" dt="2024-01-21T14:20:34.044" v="12" actId="165"/>
          <ac:grpSpMkLst>
            <pc:docMk/>
            <pc:sldMk cId="2004873951" sldId="256"/>
            <ac:grpSpMk id="2564" creationId="{BDEB5313-0316-D343-C3A1-5CECC5807C47}"/>
          </ac:grpSpMkLst>
        </pc:grpChg>
        <pc:grpChg chg="mod topLvl">
          <ac:chgData name="CARLOS COSTAS INSUA" userId="e10c8832-4d3d-4782-833a-236983bbf7b2" providerId="ADAL" clId="{4B4A3358-5FE0-4809-BC81-23DEF2B1FD97}" dt="2024-01-21T14:25:22.046" v="246" actId="555"/>
          <ac:grpSpMkLst>
            <pc:docMk/>
            <pc:sldMk cId="2004873951" sldId="256"/>
            <ac:grpSpMk id="2565" creationId="{93E59482-6BB1-7281-3E2D-8D49E1D07DD9}"/>
          </ac:grpSpMkLst>
        </pc:grpChg>
        <pc:grpChg chg="del mod topLvl">
          <ac:chgData name="CARLOS COSTAS INSUA" userId="e10c8832-4d3d-4782-833a-236983bbf7b2" providerId="ADAL" clId="{4B4A3358-5FE0-4809-BC81-23DEF2B1FD97}" dt="2024-01-21T14:20:34.044" v="12" actId="165"/>
          <ac:grpSpMkLst>
            <pc:docMk/>
            <pc:sldMk cId="2004873951" sldId="256"/>
            <ac:grpSpMk id="2586" creationId="{57C35D29-D1FF-810D-43EC-7CCCD12B22C4}"/>
          </ac:grpSpMkLst>
        </pc:grpChg>
        <pc:grpChg chg="mod topLvl">
          <ac:chgData name="CARLOS COSTAS INSUA" userId="e10c8832-4d3d-4782-833a-236983bbf7b2" providerId="ADAL" clId="{4B4A3358-5FE0-4809-BC81-23DEF2B1FD97}" dt="2024-01-21T14:26:48.658" v="349" actId="1036"/>
          <ac:grpSpMkLst>
            <pc:docMk/>
            <pc:sldMk cId="2004873951" sldId="256"/>
            <ac:grpSpMk id="2587" creationId="{4C387F59-0650-B35B-6D8B-9681AE7B2ACF}"/>
          </ac:grpSpMkLst>
        </pc:grpChg>
        <pc:grpChg chg="del mod topLvl">
          <ac:chgData name="CARLOS COSTAS INSUA" userId="e10c8832-4d3d-4782-833a-236983bbf7b2" providerId="ADAL" clId="{4B4A3358-5FE0-4809-BC81-23DEF2B1FD97}" dt="2024-01-21T14:20:34.044" v="12" actId="165"/>
          <ac:grpSpMkLst>
            <pc:docMk/>
            <pc:sldMk cId="2004873951" sldId="256"/>
            <ac:grpSpMk id="2599" creationId="{49815D71-98D3-C6C4-4F92-FF1A58A6A9D9}"/>
          </ac:grpSpMkLst>
        </pc:grpChg>
        <pc:grpChg chg="mod topLvl">
          <ac:chgData name="CARLOS COSTAS INSUA" userId="e10c8832-4d3d-4782-833a-236983bbf7b2" providerId="ADAL" clId="{4B4A3358-5FE0-4809-BC81-23DEF2B1FD97}" dt="2024-01-21T14:27:55.268" v="399" actId="1038"/>
          <ac:grpSpMkLst>
            <pc:docMk/>
            <pc:sldMk cId="2004873951" sldId="256"/>
            <ac:grpSpMk id="2600" creationId="{FE5F15FD-56F4-9BEF-8843-240E46D64B1F}"/>
          </ac:grpSpMkLst>
        </pc:grpChg>
        <pc:grpChg chg="del mod topLvl">
          <ac:chgData name="CARLOS COSTAS INSUA" userId="e10c8832-4d3d-4782-833a-236983bbf7b2" providerId="ADAL" clId="{4B4A3358-5FE0-4809-BC81-23DEF2B1FD97}" dt="2024-01-21T14:20:34.044" v="12" actId="165"/>
          <ac:grpSpMkLst>
            <pc:docMk/>
            <pc:sldMk cId="2004873951" sldId="256"/>
            <ac:grpSpMk id="2607" creationId="{7EBC1A4B-0428-FE94-9515-C7351D7542B1}"/>
          </ac:grpSpMkLst>
        </pc:grpChg>
        <pc:grpChg chg="mod topLvl">
          <ac:chgData name="CARLOS COSTAS INSUA" userId="e10c8832-4d3d-4782-833a-236983bbf7b2" providerId="ADAL" clId="{4B4A3358-5FE0-4809-BC81-23DEF2B1FD97}" dt="2024-01-21T14:28:56.645" v="431" actId="1036"/>
          <ac:grpSpMkLst>
            <pc:docMk/>
            <pc:sldMk cId="2004873951" sldId="256"/>
            <ac:grpSpMk id="2608" creationId="{8DD8EFFC-A6FB-BFB0-EA4C-D55ACECE8B1C}"/>
          </ac:grpSpMkLst>
        </pc:grpChg>
        <pc:grpChg chg="del mod topLvl">
          <ac:chgData name="CARLOS COSTAS INSUA" userId="e10c8832-4d3d-4782-833a-236983bbf7b2" providerId="ADAL" clId="{4B4A3358-5FE0-4809-BC81-23DEF2B1FD97}" dt="2024-01-21T14:20:34.044" v="12" actId="165"/>
          <ac:grpSpMkLst>
            <pc:docMk/>
            <pc:sldMk cId="2004873951" sldId="256"/>
            <ac:grpSpMk id="2613" creationId="{C19D0571-6F25-BA50-94F2-8D17D467DFF0}"/>
          </ac:grpSpMkLst>
        </pc:grpChg>
        <pc:grpChg chg="mod topLvl">
          <ac:chgData name="CARLOS COSTAS INSUA" userId="e10c8832-4d3d-4782-833a-236983bbf7b2" providerId="ADAL" clId="{4B4A3358-5FE0-4809-BC81-23DEF2B1FD97}" dt="2024-01-21T14:29:53.417" v="456" actId="1036"/>
          <ac:grpSpMkLst>
            <pc:docMk/>
            <pc:sldMk cId="2004873951" sldId="256"/>
            <ac:grpSpMk id="2614" creationId="{03020668-F3A2-7F2D-21DF-789BD0DE935D}"/>
          </ac:grpSpMkLst>
        </pc:grpChg>
        <pc:grpChg chg="del mod topLvl">
          <ac:chgData name="CARLOS COSTAS INSUA" userId="e10c8832-4d3d-4782-833a-236983bbf7b2" providerId="ADAL" clId="{4B4A3358-5FE0-4809-BC81-23DEF2B1FD97}" dt="2024-01-21T14:20:19.654" v="10" actId="165"/>
          <ac:grpSpMkLst>
            <pc:docMk/>
            <pc:sldMk cId="2004873951" sldId="256"/>
            <ac:grpSpMk id="2621" creationId="{12EBCF4B-5CB0-05B6-1DBA-5A1E74467DDC}"/>
          </ac:grpSpMkLst>
        </pc:grpChg>
        <pc:grpChg chg="del mod topLvl">
          <ac:chgData name="CARLOS COSTAS INSUA" userId="e10c8832-4d3d-4782-833a-236983bbf7b2" providerId="ADAL" clId="{4B4A3358-5FE0-4809-BC81-23DEF2B1FD97}" dt="2024-01-21T14:20:26.655" v="11" actId="165"/>
          <ac:grpSpMkLst>
            <pc:docMk/>
            <pc:sldMk cId="2004873951" sldId="256"/>
            <ac:grpSpMk id="2622" creationId="{0F07C9DB-CE01-4BD4-8E7B-77B0E59004F5}"/>
          </ac:grpSpMkLst>
        </pc:grpChg>
        <pc:grpChg chg="del mod topLvl">
          <ac:chgData name="CARLOS COSTAS INSUA" userId="e10c8832-4d3d-4782-833a-236983bbf7b2" providerId="ADAL" clId="{4B4A3358-5FE0-4809-BC81-23DEF2B1FD97}" dt="2024-01-21T14:20:26.655" v="11" actId="165"/>
          <ac:grpSpMkLst>
            <pc:docMk/>
            <pc:sldMk cId="2004873951" sldId="256"/>
            <ac:grpSpMk id="2624" creationId="{428531C5-8514-BB15-8576-F7F78996766B}"/>
          </ac:grpSpMkLst>
        </pc:grpChg>
        <pc:grpChg chg="del">
          <ac:chgData name="CARLOS COSTAS INSUA" userId="e10c8832-4d3d-4782-833a-236983bbf7b2" providerId="ADAL" clId="{4B4A3358-5FE0-4809-BC81-23DEF2B1FD97}" dt="2024-01-21T14:20:15.382" v="9" actId="165"/>
          <ac:grpSpMkLst>
            <pc:docMk/>
            <pc:sldMk cId="2004873951" sldId="256"/>
            <ac:grpSpMk id="2625" creationId="{7E63BD30-D8EB-04F6-62BE-93F7A244E192}"/>
          </ac:grpSpMkLst>
        </pc:grpChg>
        <pc:grpChg chg="del">
          <ac:chgData name="CARLOS COSTAS INSUA" userId="e10c8832-4d3d-4782-833a-236983bbf7b2" providerId="ADAL" clId="{4B4A3358-5FE0-4809-BC81-23DEF2B1FD97}" dt="2024-01-21T14:20:19.654" v="10" actId="165"/>
          <ac:grpSpMkLst>
            <pc:docMk/>
            <pc:sldMk cId="2004873951" sldId="256"/>
            <ac:grpSpMk id="2627" creationId="{04F4D224-F2FF-7073-AFBE-7E3298D06F7B}"/>
          </ac:grpSpMkLst>
        </pc:grpChg>
        <pc:grpChg chg="del">
          <ac:chgData name="CARLOS COSTAS INSUA" userId="e10c8832-4d3d-4782-833a-236983bbf7b2" providerId="ADAL" clId="{4B4A3358-5FE0-4809-BC81-23DEF2B1FD97}" dt="2024-01-21T14:20:19.654" v="10" actId="165"/>
          <ac:grpSpMkLst>
            <pc:docMk/>
            <pc:sldMk cId="2004873951" sldId="256"/>
            <ac:grpSpMk id="2628" creationId="{DCCEA666-25C0-7E68-2DFD-052C13259EC8}"/>
          </ac:grpSpMkLst>
        </pc:grpChg>
        <pc:grpChg chg="del">
          <ac:chgData name="CARLOS COSTAS INSUA" userId="e10c8832-4d3d-4782-833a-236983bbf7b2" providerId="ADAL" clId="{4B4A3358-5FE0-4809-BC81-23DEF2B1FD97}" dt="2024-01-21T14:19:26.958" v="0" actId="478"/>
          <ac:grpSpMkLst>
            <pc:docMk/>
            <pc:sldMk cId="2004873951" sldId="256"/>
            <ac:grpSpMk id="2636" creationId="{1F9E191C-778C-7B14-4229-081456194647}"/>
          </ac:grpSpMkLst>
        </pc:grpChg>
        <pc:grpChg chg="del">
          <ac:chgData name="CARLOS COSTAS INSUA" userId="e10c8832-4d3d-4782-833a-236983bbf7b2" providerId="ADAL" clId="{4B4A3358-5FE0-4809-BC81-23DEF2B1FD97}" dt="2024-01-21T14:19:26.958" v="0" actId="478"/>
          <ac:grpSpMkLst>
            <pc:docMk/>
            <pc:sldMk cId="2004873951" sldId="256"/>
            <ac:grpSpMk id="2642" creationId="{64806836-AE34-423D-8778-6DBABD0331E9}"/>
          </ac:grpSpMkLst>
        </pc:grpChg>
        <pc:grpChg chg="del">
          <ac:chgData name="CARLOS COSTAS INSUA" userId="e10c8832-4d3d-4782-833a-236983bbf7b2" providerId="ADAL" clId="{4B4A3358-5FE0-4809-BC81-23DEF2B1FD97}" dt="2024-01-21T14:19:26.958" v="0" actId="478"/>
          <ac:grpSpMkLst>
            <pc:docMk/>
            <pc:sldMk cId="2004873951" sldId="256"/>
            <ac:grpSpMk id="2659" creationId="{59E81DA0-A4E8-DA92-1536-0288735EE632}"/>
          </ac:grpSpMkLst>
        </pc:grpChg>
        <pc:grpChg chg="del">
          <ac:chgData name="CARLOS COSTAS INSUA" userId="e10c8832-4d3d-4782-833a-236983bbf7b2" providerId="ADAL" clId="{4B4A3358-5FE0-4809-BC81-23DEF2B1FD97}" dt="2024-01-21T14:19:26.958" v="0" actId="478"/>
          <ac:grpSpMkLst>
            <pc:docMk/>
            <pc:sldMk cId="2004873951" sldId="256"/>
            <ac:grpSpMk id="2661" creationId="{268DA54E-C364-20F9-65C1-A15338664BE2}"/>
          </ac:grpSpMkLst>
        </pc:grpChg>
        <pc:grpChg chg="del">
          <ac:chgData name="CARLOS COSTAS INSUA" userId="e10c8832-4d3d-4782-833a-236983bbf7b2" providerId="ADAL" clId="{4B4A3358-5FE0-4809-BC81-23DEF2B1FD97}" dt="2024-01-21T14:19:26.958" v="0" actId="478"/>
          <ac:grpSpMkLst>
            <pc:docMk/>
            <pc:sldMk cId="2004873951" sldId="256"/>
            <ac:grpSpMk id="2677" creationId="{22268DB4-2099-53D5-5C78-55E3E7A3877D}"/>
          </ac:grpSpMkLst>
        </pc:grpChg>
        <pc:grpChg chg="del">
          <ac:chgData name="CARLOS COSTAS INSUA" userId="e10c8832-4d3d-4782-833a-236983bbf7b2" providerId="ADAL" clId="{4B4A3358-5FE0-4809-BC81-23DEF2B1FD97}" dt="2024-01-21T14:19:26.958" v="0" actId="478"/>
          <ac:grpSpMkLst>
            <pc:docMk/>
            <pc:sldMk cId="2004873951" sldId="256"/>
            <ac:grpSpMk id="2678" creationId="{A0F16AB6-C6D1-107F-E2CA-61E23E1C1BFA}"/>
          </ac:grpSpMkLst>
        </pc:grpChg>
        <pc:picChg chg="add mod ord modCrop">
          <ac:chgData name="CARLOS COSTAS INSUA" userId="e10c8832-4d3d-4782-833a-236983bbf7b2" providerId="ADAL" clId="{4B4A3358-5FE0-4809-BC81-23DEF2B1FD97}" dt="2024-01-21T14:24:33.772" v="206" actId="167"/>
          <ac:picMkLst>
            <pc:docMk/>
            <pc:sldMk cId="2004873951" sldId="256"/>
            <ac:picMk id="2" creationId="{2C103F2D-E87D-FD6C-81DA-1DE8EFE94383}"/>
          </ac:picMkLst>
        </pc:picChg>
        <pc:picChg chg="add mod ord modCrop">
          <ac:chgData name="CARLOS COSTAS INSUA" userId="e10c8832-4d3d-4782-833a-236983bbf7b2" providerId="ADAL" clId="{4B4A3358-5FE0-4809-BC81-23DEF2B1FD97}" dt="2024-01-21T14:22:48.115" v="141" actId="1038"/>
          <ac:picMkLst>
            <pc:docMk/>
            <pc:sldMk cId="2004873951" sldId="256"/>
            <ac:picMk id="3" creationId="{09F9F65A-3C1C-BBB2-2A16-88B936E22341}"/>
          </ac:picMkLst>
        </pc:picChg>
        <pc:picChg chg="add mod ord modCrop">
          <ac:chgData name="CARLOS COSTAS INSUA" userId="e10c8832-4d3d-4782-833a-236983bbf7b2" providerId="ADAL" clId="{4B4A3358-5FE0-4809-BC81-23DEF2B1FD97}" dt="2024-01-21T14:27:43.144" v="362" actId="167"/>
          <ac:picMkLst>
            <pc:docMk/>
            <pc:sldMk cId="2004873951" sldId="256"/>
            <ac:picMk id="4" creationId="{D3F5FD41-0AC7-3349-E7EA-60BCB90724CB}"/>
          </ac:picMkLst>
        </pc:picChg>
        <pc:picChg chg="add mod ord modCrop">
          <ac:chgData name="CARLOS COSTAS INSUA" userId="e10c8832-4d3d-4782-833a-236983bbf7b2" providerId="ADAL" clId="{4B4A3358-5FE0-4809-BC81-23DEF2B1FD97}" dt="2024-01-21T14:26:27.482" v="293" actId="167"/>
          <ac:picMkLst>
            <pc:docMk/>
            <pc:sldMk cId="2004873951" sldId="256"/>
            <ac:picMk id="5" creationId="{92DA38AA-CBEA-CB3F-1BB1-4A55E43FE986}"/>
          </ac:picMkLst>
        </pc:picChg>
        <pc:picChg chg="add mod ord modCrop">
          <ac:chgData name="CARLOS COSTAS INSUA" userId="e10c8832-4d3d-4782-833a-236983bbf7b2" providerId="ADAL" clId="{4B4A3358-5FE0-4809-BC81-23DEF2B1FD97}" dt="2024-01-21T14:29:43.481" v="444" actId="167"/>
          <ac:picMkLst>
            <pc:docMk/>
            <pc:sldMk cId="2004873951" sldId="256"/>
            <ac:picMk id="6" creationId="{CBABFF90-748D-0A2B-D687-F1F8D175CC6F}"/>
          </ac:picMkLst>
        </pc:picChg>
        <pc:picChg chg="add mod ord modCrop">
          <ac:chgData name="CARLOS COSTAS INSUA" userId="e10c8832-4d3d-4782-833a-236983bbf7b2" providerId="ADAL" clId="{4B4A3358-5FE0-4809-BC81-23DEF2B1FD97}" dt="2024-01-21T14:28:43.804" v="415" actId="167"/>
          <ac:picMkLst>
            <pc:docMk/>
            <pc:sldMk cId="2004873951" sldId="256"/>
            <ac:picMk id="7" creationId="{286B6A96-76FB-38A7-5132-6E6472A81A8B}"/>
          </ac:picMkLst>
        </pc:picChg>
        <pc:picChg chg="del">
          <ac:chgData name="CARLOS COSTAS INSUA" userId="e10c8832-4d3d-4782-833a-236983bbf7b2" providerId="ADAL" clId="{4B4A3358-5FE0-4809-BC81-23DEF2B1FD97}" dt="2024-01-21T14:19:26.958" v="0" actId="478"/>
          <ac:picMkLst>
            <pc:docMk/>
            <pc:sldMk cId="2004873951" sldId="256"/>
            <ac:picMk id="1276" creationId="{9AA9593A-01C5-86D4-0807-1F8D5A175024}"/>
          </ac:picMkLst>
        </pc:picChg>
        <pc:picChg chg="del">
          <ac:chgData name="CARLOS COSTAS INSUA" userId="e10c8832-4d3d-4782-833a-236983bbf7b2" providerId="ADAL" clId="{4B4A3358-5FE0-4809-BC81-23DEF2B1FD97}" dt="2024-01-21T14:19:26.958" v="0" actId="478"/>
          <ac:picMkLst>
            <pc:docMk/>
            <pc:sldMk cId="2004873951" sldId="256"/>
            <ac:picMk id="1277" creationId="{A59613A2-F7EB-6670-31BA-27BD5C1843F2}"/>
          </ac:picMkLst>
        </pc:picChg>
        <pc:picChg chg="del">
          <ac:chgData name="CARLOS COSTAS INSUA" userId="e10c8832-4d3d-4782-833a-236983bbf7b2" providerId="ADAL" clId="{4B4A3358-5FE0-4809-BC81-23DEF2B1FD97}" dt="2024-01-21T14:19:26.958" v="0" actId="478"/>
          <ac:picMkLst>
            <pc:docMk/>
            <pc:sldMk cId="2004873951" sldId="256"/>
            <ac:picMk id="1842" creationId="{200C4773-7BC4-3850-8779-A73114D1F8C8}"/>
          </ac:picMkLst>
        </pc:picChg>
        <pc:picChg chg="del">
          <ac:chgData name="CARLOS COSTAS INSUA" userId="e10c8832-4d3d-4782-833a-236983bbf7b2" providerId="ADAL" clId="{4B4A3358-5FE0-4809-BC81-23DEF2B1FD97}" dt="2024-01-21T14:19:26.958" v="0" actId="478"/>
          <ac:picMkLst>
            <pc:docMk/>
            <pc:sldMk cId="2004873951" sldId="256"/>
            <ac:picMk id="1843" creationId="{2C7F9231-2A6B-1102-DA35-EAF77D70C792}"/>
          </ac:picMkLst>
        </pc:picChg>
        <pc:picChg chg="del">
          <ac:chgData name="CARLOS COSTAS INSUA" userId="e10c8832-4d3d-4782-833a-236983bbf7b2" providerId="ADAL" clId="{4B4A3358-5FE0-4809-BC81-23DEF2B1FD97}" dt="2024-01-21T14:19:26.958" v="0" actId="478"/>
          <ac:picMkLst>
            <pc:docMk/>
            <pc:sldMk cId="2004873951" sldId="256"/>
            <ac:picMk id="1902" creationId="{FD5CB626-8140-808F-A626-C7D5AA4D38E9}"/>
          </ac:picMkLst>
        </pc:picChg>
        <pc:picChg chg="del">
          <ac:chgData name="CARLOS COSTAS INSUA" userId="e10c8832-4d3d-4782-833a-236983bbf7b2" providerId="ADAL" clId="{4B4A3358-5FE0-4809-BC81-23DEF2B1FD97}" dt="2024-01-21T14:19:26.958" v="0" actId="478"/>
          <ac:picMkLst>
            <pc:docMk/>
            <pc:sldMk cId="2004873951" sldId="256"/>
            <ac:picMk id="1903" creationId="{73D01273-A618-9FBA-4125-F00CB8784806}"/>
          </ac:picMkLst>
        </pc:picChg>
        <pc:picChg chg="del mod topLvl">
          <ac:chgData name="CARLOS COSTAS INSUA" userId="e10c8832-4d3d-4782-833a-236983bbf7b2" providerId="ADAL" clId="{4B4A3358-5FE0-4809-BC81-23DEF2B1FD97}" dt="2024-01-21T14:29:45.075" v="445" actId="478"/>
          <ac:picMkLst>
            <pc:docMk/>
            <pc:sldMk cId="2004873951" sldId="256"/>
            <ac:picMk id="2014" creationId="{A78E13CF-1788-408E-674D-1E5B5078A223}"/>
          </ac:picMkLst>
        </pc:picChg>
        <pc:picChg chg="del mod topLvl">
          <ac:chgData name="CARLOS COSTAS INSUA" userId="e10c8832-4d3d-4782-833a-236983bbf7b2" providerId="ADAL" clId="{4B4A3358-5FE0-4809-BC81-23DEF2B1FD97}" dt="2024-01-21T14:28:45.460" v="416" actId="478"/>
          <ac:picMkLst>
            <pc:docMk/>
            <pc:sldMk cId="2004873951" sldId="256"/>
            <ac:picMk id="2015" creationId="{06D18087-46F9-9C3E-A5C0-434D55DCF02D}"/>
          </ac:picMkLst>
        </pc:picChg>
        <pc:picChg chg="del mod topLvl">
          <ac:chgData name="CARLOS COSTAS INSUA" userId="e10c8832-4d3d-4782-833a-236983bbf7b2" providerId="ADAL" clId="{4B4A3358-5FE0-4809-BC81-23DEF2B1FD97}" dt="2024-01-21T14:20:53.688" v="17" actId="478"/>
          <ac:picMkLst>
            <pc:docMk/>
            <pc:sldMk cId="2004873951" sldId="256"/>
            <ac:picMk id="2546" creationId="{7B76D1BB-904C-0F50-FCDF-FAD01C223EC3}"/>
          </ac:picMkLst>
        </pc:picChg>
        <pc:picChg chg="del mod topLvl">
          <ac:chgData name="CARLOS COSTAS INSUA" userId="e10c8832-4d3d-4782-833a-236983bbf7b2" providerId="ADAL" clId="{4B4A3358-5FE0-4809-BC81-23DEF2B1FD97}" dt="2024-01-21T14:24:35.521" v="207" actId="478"/>
          <ac:picMkLst>
            <pc:docMk/>
            <pc:sldMk cId="2004873951" sldId="256"/>
            <ac:picMk id="2548" creationId="{314494E4-2CD1-F029-B050-2BA6509C13B8}"/>
          </ac:picMkLst>
        </pc:picChg>
        <pc:picChg chg="del mod topLvl">
          <ac:chgData name="CARLOS COSTAS INSUA" userId="e10c8832-4d3d-4782-833a-236983bbf7b2" providerId="ADAL" clId="{4B4A3358-5FE0-4809-BC81-23DEF2B1FD97}" dt="2024-01-21T14:26:29.419" v="294" actId="478"/>
          <ac:picMkLst>
            <pc:docMk/>
            <pc:sldMk cId="2004873951" sldId="256"/>
            <ac:picMk id="2583" creationId="{56028FBE-4ACE-25E6-DFF2-C93079F13C98}"/>
          </ac:picMkLst>
        </pc:picChg>
        <pc:picChg chg="del mod topLvl">
          <ac:chgData name="CARLOS COSTAS INSUA" userId="e10c8832-4d3d-4782-833a-236983bbf7b2" providerId="ADAL" clId="{4B4A3358-5FE0-4809-BC81-23DEF2B1FD97}" dt="2024-01-21T14:27:44.816" v="363" actId="478"/>
          <ac:picMkLst>
            <pc:docMk/>
            <pc:sldMk cId="2004873951" sldId="256"/>
            <ac:picMk id="2593" creationId="{70BCB204-2788-EFE8-D077-CE305C51CBDF}"/>
          </ac:picMkLst>
        </pc:picChg>
      </pc:sldChg>
    </pc:docChg>
  </pc:docChgLst>
  <pc:docChgLst>
    <pc:chgData name="ALBA HERMOSO LOPEZ" userId="02ef7285-0ce8-4b94-9570-ba0379b98708" providerId="ADAL" clId="{FF8ABBA2-5110-4979-8823-5762E90226AD}"/>
    <pc:docChg chg="modSld">
      <pc:chgData name="ALBA HERMOSO LOPEZ" userId="02ef7285-0ce8-4b94-9570-ba0379b98708" providerId="ADAL" clId="{FF8ABBA2-5110-4979-8823-5762E90226AD}" dt="2024-01-24T12:33:54.619" v="23" actId="20577"/>
      <pc:docMkLst>
        <pc:docMk/>
      </pc:docMkLst>
      <pc:sldChg chg="modSp mod">
        <pc:chgData name="ALBA HERMOSO LOPEZ" userId="02ef7285-0ce8-4b94-9570-ba0379b98708" providerId="ADAL" clId="{FF8ABBA2-5110-4979-8823-5762E90226AD}" dt="2024-01-24T12:33:54.619" v="23" actId="20577"/>
        <pc:sldMkLst>
          <pc:docMk/>
          <pc:sldMk cId="2004873951" sldId="256"/>
        </pc:sldMkLst>
        <pc:spChg chg="mod">
          <ac:chgData name="ALBA HERMOSO LOPEZ" userId="02ef7285-0ce8-4b94-9570-ba0379b98708" providerId="ADAL" clId="{FF8ABBA2-5110-4979-8823-5762E90226AD}" dt="2024-01-24T12:33:54.619" v="23" actId="20577"/>
          <ac:spMkLst>
            <pc:docMk/>
            <pc:sldMk cId="2004873951" sldId="256"/>
            <ac:spMk id="16" creationId="{788656F0-61BE-04FF-BD32-022699997E24}"/>
          </ac:spMkLst>
        </pc:spChg>
        <pc:spChg chg="mod">
          <ac:chgData name="ALBA HERMOSO LOPEZ" userId="02ef7285-0ce8-4b94-9570-ba0379b98708" providerId="ADAL" clId="{FF8ABBA2-5110-4979-8823-5762E90226AD}" dt="2024-01-24T12:33:35.029" v="11" actId="20577"/>
          <ac:spMkLst>
            <pc:docMk/>
            <pc:sldMk cId="2004873951" sldId="256"/>
            <ac:spMk id="17" creationId="{9F7127FD-A260-CD52-7A25-88480D36CE2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93631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978489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82748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917597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13455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165739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470652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047536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66391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118848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48144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93404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microsoft.com/office/2007/relationships/hdphoto" Target="../media/hdphoto1.wdp"/><Relationship Id="rId7" Type="http://schemas.openxmlformats.org/officeDocument/2006/relationships/image" Target="../media/image4.jp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jpg"/><Relationship Id="rId11" Type="http://schemas.microsoft.com/office/2007/relationships/hdphoto" Target="../media/hdphoto4.wdp"/><Relationship Id="rId5" Type="http://schemas.microsoft.com/office/2007/relationships/hdphoto" Target="../media/hdphoto2.wdp"/><Relationship Id="rId10" Type="http://schemas.openxmlformats.org/officeDocument/2006/relationships/image" Target="../media/image6.png"/><Relationship Id="rId4" Type="http://schemas.openxmlformats.org/officeDocument/2006/relationships/image" Target="../media/image2.png"/><Relationship Id="rId9" Type="http://schemas.microsoft.com/office/2007/relationships/hdphoto" Target="../media/hdphoto3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upo 17">
            <a:extLst>
              <a:ext uri="{FF2B5EF4-FFF2-40B4-BE49-F238E27FC236}">
                <a16:creationId xmlns:a16="http://schemas.microsoft.com/office/drawing/2014/main" id="{ED4E88FF-1356-D079-00F3-4CCB3A1A46DB}"/>
              </a:ext>
            </a:extLst>
          </p:cNvPr>
          <p:cNvGrpSpPr/>
          <p:nvPr/>
        </p:nvGrpSpPr>
        <p:grpSpPr>
          <a:xfrm>
            <a:off x="190041" y="164592"/>
            <a:ext cx="6667959" cy="4522383"/>
            <a:chOff x="190041" y="164592"/>
            <a:chExt cx="6667959" cy="4522383"/>
          </a:xfrm>
        </p:grpSpPr>
        <p:pic>
          <p:nvPicPr>
            <p:cNvPr id="6" name="Imagen 5" descr="Imagen que contiene interior, tabla, mostrador, cocina&#10;&#10;Descripción generada automáticamente">
              <a:extLst>
                <a:ext uri="{FF2B5EF4-FFF2-40B4-BE49-F238E27FC236}">
                  <a16:creationId xmlns:a16="http://schemas.microsoft.com/office/drawing/2014/main" id="{CBABFF90-748D-0A2B-D687-F1F8D175CC6F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847" t="17718" r="8497" b="16776"/>
            <a:stretch/>
          </p:blipFill>
          <p:spPr>
            <a:xfrm>
              <a:off x="3512126" y="3348109"/>
              <a:ext cx="2804400" cy="10224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7" name="Imagen 6" descr="Imagen que contiene interior, pequeño, mostrador, cocina&#10;&#10;Descripción generada automáticamente">
              <a:extLst>
                <a:ext uri="{FF2B5EF4-FFF2-40B4-BE49-F238E27FC236}">
                  <a16:creationId xmlns:a16="http://schemas.microsoft.com/office/drawing/2014/main" id="{286B6A96-76FB-38A7-5132-6E6472A81A8B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59" t="18758" r="9858" b="26222"/>
            <a:stretch/>
          </p:blipFill>
          <p:spPr>
            <a:xfrm>
              <a:off x="291383" y="3348109"/>
              <a:ext cx="2804400" cy="10224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4" name="Imagen 3" descr="Imagen que contiene interior, gato, sucio, cocina&#10;&#10;Descripción generada automáticamente">
              <a:extLst>
                <a:ext uri="{FF2B5EF4-FFF2-40B4-BE49-F238E27FC236}">
                  <a16:creationId xmlns:a16="http://schemas.microsoft.com/office/drawing/2014/main" id="{D3F5FD41-0AC7-3349-E7EA-60BCB90724CB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6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61" t="23176" r="7862" b="17986"/>
            <a:stretch/>
          </p:blipFill>
          <p:spPr>
            <a:xfrm>
              <a:off x="3508256" y="2000380"/>
              <a:ext cx="2804400" cy="10224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5" name="Imagen 4" descr="Imagen que contiene interior, cocina, pequeño, refrigerador&#10;&#10;Descripción generada automáticamente">
              <a:extLst>
                <a:ext uri="{FF2B5EF4-FFF2-40B4-BE49-F238E27FC236}">
                  <a16:creationId xmlns:a16="http://schemas.microsoft.com/office/drawing/2014/main" id="{92DA38AA-CBEA-CB3F-1BB1-4A55E43FE986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7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34" t="20343" r="11196" b="27484"/>
            <a:stretch/>
          </p:blipFill>
          <p:spPr>
            <a:xfrm>
              <a:off x="287513" y="2000380"/>
              <a:ext cx="2804400" cy="10224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2" name="Imagen 1" descr="Imagen que contiene interior, cocina, tabla, gato&#10;&#10;Descripción generada automáticamente">
              <a:extLst>
                <a:ext uri="{FF2B5EF4-FFF2-40B4-BE49-F238E27FC236}">
                  <a16:creationId xmlns:a16="http://schemas.microsoft.com/office/drawing/2014/main" id="{2C103F2D-E87D-FD6C-81DA-1DE8EFE94383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8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131" t="21147" r="6319" b="20453"/>
            <a:stretch/>
          </p:blipFill>
          <p:spPr>
            <a:xfrm>
              <a:off x="3509697" y="597938"/>
              <a:ext cx="2804400" cy="10224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3" name="Imagen 2" descr="Imagen que contiene interior, cocina, cuarto, cama&#10;&#10;Descripción generada automáticamente">
              <a:extLst>
                <a:ext uri="{FF2B5EF4-FFF2-40B4-BE49-F238E27FC236}">
                  <a16:creationId xmlns:a16="http://schemas.microsoft.com/office/drawing/2014/main" id="{09F9F65A-3C1C-BBB2-2A16-88B936E22341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0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650" t="26347" r="7345" b="16814"/>
            <a:stretch/>
          </p:blipFill>
          <p:spPr>
            <a:xfrm>
              <a:off x="287513" y="597938"/>
              <a:ext cx="2804400" cy="10224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1754" name="CuadroTexto 1753">
              <a:extLst>
                <a:ext uri="{FF2B5EF4-FFF2-40B4-BE49-F238E27FC236}">
                  <a16:creationId xmlns:a16="http://schemas.microsoft.com/office/drawing/2014/main" id="{05907BE4-EAE5-6026-200F-8E7E984B2864}"/>
                </a:ext>
              </a:extLst>
            </p:cNvPr>
            <p:cNvSpPr txBox="1"/>
            <p:nvPr/>
          </p:nvSpPr>
          <p:spPr>
            <a:xfrm>
              <a:off x="4376615" y="164592"/>
              <a:ext cx="248138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Figure EV4A – </a:t>
              </a:r>
              <a:r>
                <a:rPr lang="es-ES" sz="12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Uncropped</a:t>
              </a:r>
              <a:r>
                <a:rPr lang="es-E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12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Bs</a:t>
              </a:r>
              <a:endParaRPr lang="es-ES" sz="12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362" name="CuadroTexto 1361">
              <a:extLst>
                <a:ext uri="{FF2B5EF4-FFF2-40B4-BE49-F238E27FC236}">
                  <a16:creationId xmlns:a16="http://schemas.microsoft.com/office/drawing/2014/main" id="{A0D1A375-D2D6-FD4A-6775-D426EC941C6A}"/>
                </a:ext>
              </a:extLst>
            </p:cNvPr>
            <p:cNvSpPr txBox="1"/>
            <p:nvPr/>
          </p:nvSpPr>
          <p:spPr>
            <a:xfrm>
              <a:off x="209609" y="1618909"/>
              <a:ext cx="2674964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CB</a:t>
              </a:r>
              <a:r>
                <a:rPr lang="es-ES" sz="750" baseline="-25000" dirty="0">
                  <a:latin typeface="Helvetica" panose="020B0604020202020204" pitchFamily="34" charset="0"/>
                  <a:cs typeface="Helvetica" panose="020B0604020202020204" pitchFamily="34" charset="0"/>
                </a:rPr>
                <a:t>1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R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hippocampa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xtracts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from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CRBN-WT/KO and CB</a:t>
              </a:r>
              <a:r>
                <a:rPr lang="es-ES" sz="750" baseline="-25000" dirty="0">
                  <a:latin typeface="Helvetica" panose="020B0604020202020204" pitchFamily="34" charset="0"/>
                  <a:cs typeface="Helvetica" panose="020B0604020202020204" pitchFamily="34" charset="0"/>
                </a:rPr>
                <a:t>1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R-KO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mic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553" name="CuadroTexto 2552">
              <a:extLst>
                <a:ext uri="{FF2B5EF4-FFF2-40B4-BE49-F238E27FC236}">
                  <a16:creationId xmlns:a16="http://schemas.microsoft.com/office/drawing/2014/main" id="{75DAD5D6-EE9B-3F86-4DB1-13AFD23F71BE}"/>
                </a:ext>
              </a:extLst>
            </p:cNvPr>
            <p:cNvSpPr txBox="1"/>
            <p:nvPr/>
          </p:nvSpPr>
          <p:spPr>
            <a:xfrm>
              <a:off x="3431311" y="1618909"/>
              <a:ext cx="2674964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Hsp90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hippocampa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xtracts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from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CRBN-WT/KO and CB</a:t>
              </a:r>
              <a:r>
                <a:rPr lang="es-ES" sz="750" baseline="-25000" dirty="0">
                  <a:latin typeface="Helvetica" panose="020B0604020202020204" pitchFamily="34" charset="0"/>
                  <a:cs typeface="Helvetica" panose="020B0604020202020204" pitchFamily="34" charset="0"/>
                </a:rPr>
                <a:t>1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R-KO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mic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2557" name="Grupo 2556">
              <a:extLst>
                <a:ext uri="{FF2B5EF4-FFF2-40B4-BE49-F238E27FC236}">
                  <a16:creationId xmlns:a16="http://schemas.microsoft.com/office/drawing/2014/main" id="{85D37F30-EFB2-3857-7DD5-F7FA8A37B3E0}"/>
                </a:ext>
              </a:extLst>
            </p:cNvPr>
            <p:cNvGrpSpPr/>
            <p:nvPr/>
          </p:nvGrpSpPr>
          <p:grpSpPr>
            <a:xfrm>
              <a:off x="3497417" y="1100941"/>
              <a:ext cx="284052" cy="495940"/>
              <a:chOff x="3859899" y="751179"/>
              <a:chExt cx="284052" cy="495940"/>
            </a:xfrm>
          </p:grpSpPr>
          <p:sp>
            <p:nvSpPr>
              <p:cNvPr id="2554" name="CuadroTexto 2553">
                <a:extLst>
                  <a:ext uri="{FF2B5EF4-FFF2-40B4-BE49-F238E27FC236}">
                    <a16:creationId xmlns:a16="http://schemas.microsoft.com/office/drawing/2014/main" id="{B0CF2F16-ED7E-E99E-EFF7-B0615AC4E336}"/>
                  </a:ext>
                </a:extLst>
              </p:cNvPr>
              <p:cNvSpPr txBox="1"/>
              <p:nvPr/>
            </p:nvSpPr>
            <p:spPr>
              <a:xfrm>
                <a:off x="3859899" y="751179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75</a:t>
                </a:r>
              </a:p>
            </p:txBody>
          </p:sp>
          <p:sp>
            <p:nvSpPr>
              <p:cNvPr id="2555" name="CuadroTexto 2554">
                <a:extLst>
                  <a:ext uri="{FF2B5EF4-FFF2-40B4-BE49-F238E27FC236}">
                    <a16:creationId xmlns:a16="http://schemas.microsoft.com/office/drawing/2014/main" id="{743B99BA-D5E8-8BE3-28D3-1D1C7A4119F3}"/>
                  </a:ext>
                </a:extLst>
              </p:cNvPr>
              <p:cNvSpPr txBox="1"/>
              <p:nvPr/>
            </p:nvSpPr>
            <p:spPr>
              <a:xfrm>
                <a:off x="3859899" y="932635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50</a:t>
                </a:r>
              </a:p>
            </p:txBody>
          </p:sp>
          <p:sp>
            <p:nvSpPr>
              <p:cNvPr id="2556" name="CuadroTexto 2555">
                <a:extLst>
                  <a:ext uri="{FF2B5EF4-FFF2-40B4-BE49-F238E27FC236}">
                    <a16:creationId xmlns:a16="http://schemas.microsoft.com/office/drawing/2014/main" id="{A934634D-990D-C344-A2A4-F1B6656D0C5D}"/>
                  </a:ext>
                </a:extLst>
              </p:cNvPr>
              <p:cNvSpPr txBox="1"/>
              <p:nvPr/>
            </p:nvSpPr>
            <p:spPr>
              <a:xfrm>
                <a:off x="3859899" y="1047064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37</a:t>
                </a:r>
              </a:p>
            </p:txBody>
          </p:sp>
        </p:grpSp>
        <p:sp>
          <p:nvSpPr>
            <p:cNvPr id="2562" name="CuadroTexto 2561">
              <a:extLst>
                <a:ext uri="{FF2B5EF4-FFF2-40B4-BE49-F238E27FC236}">
                  <a16:creationId xmlns:a16="http://schemas.microsoft.com/office/drawing/2014/main" id="{964DE709-22DD-7CB7-AB8A-93AA6455A50E}"/>
                </a:ext>
              </a:extLst>
            </p:cNvPr>
            <p:cNvSpPr txBox="1"/>
            <p:nvPr/>
          </p:nvSpPr>
          <p:spPr>
            <a:xfrm>
              <a:off x="3444119" y="679788"/>
              <a:ext cx="35779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err="1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KDa</a:t>
              </a:r>
              <a:endParaRPr lang="es-ES" sz="700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2565" name="Grupo 2564">
              <a:extLst>
                <a:ext uri="{FF2B5EF4-FFF2-40B4-BE49-F238E27FC236}">
                  <a16:creationId xmlns:a16="http://schemas.microsoft.com/office/drawing/2014/main" id="{93E59482-6BB1-7281-3E2D-8D49E1D07DD9}"/>
                </a:ext>
              </a:extLst>
            </p:cNvPr>
            <p:cNvGrpSpPr/>
            <p:nvPr/>
          </p:nvGrpSpPr>
          <p:grpSpPr>
            <a:xfrm>
              <a:off x="308749" y="1191537"/>
              <a:ext cx="284052" cy="459848"/>
              <a:chOff x="3859899" y="823846"/>
              <a:chExt cx="284052" cy="459848"/>
            </a:xfrm>
          </p:grpSpPr>
          <p:sp>
            <p:nvSpPr>
              <p:cNvPr id="2567" name="CuadroTexto 2566">
                <a:extLst>
                  <a:ext uri="{FF2B5EF4-FFF2-40B4-BE49-F238E27FC236}">
                    <a16:creationId xmlns:a16="http://schemas.microsoft.com/office/drawing/2014/main" id="{CF7D08F4-A638-CA13-4285-D0CEBB3F35E1}"/>
                  </a:ext>
                </a:extLst>
              </p:cNvPr>
              <p:cNvSpPr txBox="1"/>
              <p:nvPr/>
            </p:nvSpPr>
            <p:spPr>
              <a:xfrm>
                <a:off x="3859899" y="823846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75</a:t>
                </a:r>
              </a:p>
            </p:txBody>
          </p:sp>
          <p:sp>
            <p:nvSpPr>
              <p:cNvPr id="2568" name="CuadroTexto 2567">
                <a:extLst>
                  <a:ext uri="{FF2B5EF4-FFF2-40B4-BE49-F238E27FC236}">
                    <a16:creationId xmlns:a16="http://schemas.microsoft.com/office/drawing/2014/main" id="{292FE5CD-44B9-9B72-C209-7E2E81FABDD3}"/>
                  </a:ext>
                </a:extLst>
              </p:cNvPr>
              <p:cNvSpPr txBox="1"/>
              <p:nvPr/>
            </p:nvSpPr>
            <p:spPr>
              <a:xfrm>
                <a:off x="3859899" y="950803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50</a:t>
                </a:r>
              </a:p>
            </p:txBody>
          </p:sp>
          <p:sp>
            <p:nvSpPr>
              <p:cNvPr id="2569" name="CuadroTexto 2568">
                <a:extLst>
                  <a:ext uri="{FF2B5EF4-FFF2-40B4-BE49-F238E27FC236}">
                    <a16:creationId xmlns:a16="http://schemas.microsoft.com/office/drawing/2014/main" id="{84C7EB1B-7D89-7097-0E6C-D538858D6079}"/>
                  </a:ext>
                </a:extLst>
              </p:cNvPr>
              <p:cNvSpPr txBox="1"/>
              <p:nvPr/>
            </p:nvSpPr>
            <p:spPr>
              <a:xfrm>
                <a:off x="3859899" y="1083639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37</a:t>
                </a:r>
              </a:p>
            </p:txBody>
          </p:sp>
        </p:grpSp>
        <p:sp>
          <p:nvSpPr>
            <p:cNvPr id="2566" name="CuadroTexto 2565">
              <a:extLst>
                <a:ext uri="{FF2B5EF4-FFF2-40B4-BE49-F238E27FC236}">
                  <a16:creationId xmlns:a16="http://schemas.microsoft.com/office/drawing/2014/main" id="{186620A4-910C-F2F2-E1C8-015FF2EF112A}"/>
                </a:ext>
              </a:extLst>
            </p:cNvPr>
            <p:cNvSpPr txBox="1"/>
            <p:nvPr/>
          </p:nvSpPr>
          <p:spPr>
            <a:xfrm>
              <a:off x="255451" y="652759"/>
              <a:ext cx="35779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err="1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KDa</a:t>
              </a:r>
              <a:endParaRPr lang="es-ES" sz="700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2608" name="Grupo 2607">
              <a:extLst>
                <a:ext uri="{FF2B5EF4-FFF2-40B4-BE49-F238E27FC236}">
                  <a16:creationId xmlns:a16="http://schemas.microsoft.com/office/drawing/2014/main" id="{8DD8EFFC-A6FB-BFB0-EA4C-D55ACECE8B1C}"/>
                </a:ext>
              </a:extLst>
            </p:cNvPr>
            <p:cNvGrpSpPr/>
            <p:nvPr/>
          </p:nvGrpSpPr>
          <p:grpSpPr>
            <a:xfrm>
              <a:off x="279665" y="3794052"/>
              <a:ext cx="284052" cy="459848"/>
              <a:chOff x="3859899" y="823846"/>
              <a:chExt cx="284052" cy="459848"/>
            </a:xfrm>
          </p:grpSpPr>
          <p:sp>
            <p:nvSpPr>
              <p:cNvPr id="2610" name="CuadroTexto 2609">
                <a:extLst>
                  <a:ext uri="{FF2B5EF4-FFF2-40B4-BE49-F238E27FC236}">
                    <a16:creationId xmlns:a16="http://schemas.microsoft.com/office/drawing/2014/main" id="{A3641947-9787-BE43-AFBD-16700B391F8E}"/>
                  </a:ext>
                </a:extLst>
              </p:cNvPr>
              <p:cNvSpPr txBox="1"/>
              <p:nvPr/>
            </p:nvSpPr>
            <p:spPr>
              <a:xfrm>
                <a:off x="3859899" y="823846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75</a:t>
                </a:r>
              </a:p>
            </p:txBody>
          </p:sp>
          <p:sp>
            <p:nvSpPr>
              <p:cNvPr id="2611" name="CuadroTexto 2610">
                <a:extLst>
                  <a:ext uri="{FF2B5EF4-FFF2-40B4-BE49-F238E27FC236}">
                    <a16:creationId xmlns:a16="http://schemas.microsoft.com/office/drawing/2014/main" id="{7C81E3A2-3E7B-236D-46BE-7458C8A58072}"/>
                  </a:ext>
                </a:extLst>
              </p:cNvPr>
              <p:cNvSpPr txBox="1"/>
              <p:nvPr/>
            </p:nvSpPr>
            <p:spPr>
              <a:xfrm>
                <a:off x="3859899" y="950803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50</a:t>
                </a:r>
              </a:p>
            </p:txBody>
          </p:sp>
          <p:sp>
            <p:nvSpPr>
              <p:cNvPr id="2612" name="CuadroTexto 2611">
                <a:extLst>
                  <a:ext uri="{FF2B5EF4-FFF2-40B4-BE49-F238E27FC236}">
                    <a16:creationId xmlns:a16="http://schemas.microsoft.com/office/drawing/2014/main" id="{5BDCF062-D6CD-D9B2-0D34-4F419E6C1456}"/>
                  </a:ext>
                </a:extLst>
              </p:cNvPr>
              <p:cNvSpPr txBox="1"/>
              <p:nvPr/>
            </p:nvSpPr>
            <p:spPr>
              <a:xfrm>
                <a:off x="3859899" y="1083639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37</a:t>
                </a:r>
              </a:p>
            </p:txBody>
          </p:sp>
        </p:grpSp>
        <p:sp>
          <p:nvSpPr>
            <p:cNvPr id="2609" name="CuadroTexto 2608">
              <a:extLst>
                <a:ext uri="{FF2B5EF4-FFF2-40B4-BE49-F238E27FC236}">
                  <a16:creationId xmlns:a16="http://schemas.microsoft.com/office/drawing/2014/main" id="{61BE3052-B485-1610-03AF-A1995B48DCFF}"/>
                </a:ext>
              </a:extLst>
            </p:cNvPr>
            <p:cNvSpPr txBox="1"/>
            <p:nvPr/>
          </p:nvSpPr>
          <p:spPr>
            <a:xfrm>
              <a:off x="226367" y="3372088"/>
              <a:ext cx="35779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err="1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KDa</a:t>
              </a:r>
              <a:endParaRPr lang="es-ES" sz="700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2614" name="Grupo 2613">
              <a:extLst>
                <a:ext uri="{FF2B5EF4-FFF2-40B4-BE49-F238E27FC236}">
                  <a16:creationId xmlns:a16="http://schemas.microsoft.com/office/drawing/2014/main" id="{03020668-F3A2-7F2D-21DF-789BD0DE935D}"/>
                </a:ext>
              </a:extLst>
            </p:cNvPr>
            <p:cNvGrpSpPr/>
            <p:nvPr/>
          </p:nvGrpSpPr>
          <p:grpSpPr>
            <a:xfrm>
              <a:off x="3482847" y="3724900"/>
              <a:ext cx="284052" cy="459848"/>
              <a:chOff x="3859899" y="823846"/>
              <a:chExt cx="284052" cy="459848"/>
            </a:xfrm>
          </p:grpSpPr>
          <p:sp>
            <p:nvSpPr>
              <p:cNvPr id="2616" name="CuadroTexto 2615">
                <a:extLst>
                  <a:ext uri="{FF2B5EF4-FFF2-40B4-BE49-F238E27FC236}">
                    <a16:creationId xmlns:a16="http://schemas.microsoft.com/office/drawing/2014/main" id="{DFC6E288-8BA8-CCD2-4FD7-51A15F2A9102}"/>
                  </a:ext>
                </a:extLst>
              </p:cNvPr>
              <p:cNvSpPr txBox="1"/>
              <p:nvPr/>
            </p:nvSpPr>
            <p:spPr>
              <a:xfrm>
                <a:off x="3859899" y="823846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75</a:t>
                </a:r>
              </a:p>
            </p:txBody>
          </p:sp>
          <p:sp>
            <p:nvSpPr>
              <p:cNvPr id="2617" name="CuadroTexto 2616">
                <a:extLst>
                  <a:ext uri="{FF2B5EF4-FFF2-40B4-BE49-F238E27FC236}">
                    <a16:creationId xmlns:a16="http://schemas.microsoft.com/office/drawing/2014/main" id="{D7B62601-EA4D-2D38-EF19-DEF6655CF8AB}"/>
                  </a:ext>
                </a:extLst>
              </p:cNvPr>
              <p:cNvSpPr txBox="1"/>
              <p:nvPr/>
            </p:nvSpPr>
            <p:spPr>
              <a:xfrm>
                <a:off x="3859899" y="950803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50</a:t>
                </a:r>
              </a:p>
            </p:txBody>
          </p:sp>
          <p:sp>
            <p:nvSpPr>
              <p:cNvPr id="2618" name="CuadroTexto 2617">
                <a:extLst>
                  <a:ext uri="{FF2B5EF4-FFF2-40B4-BE49-F238E27FC236}">
                    <a16:creationId xmlns:a16="http://schemas.microsoft.com/office/drawing/2014/main" id="{8077C167-0E79-3690-66C1-BBF75698FD6F}"/>
                  </a:ext>
                </a:extLst>
              </p:cNvPr>
              <p:cNvSpPr txBox="1"/>
              <p:nvPr/>
            </p:nvSpPr>
            <p:spPr>
              <a:xfrm>
                <a:off x="3859899" y="1083639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37</a:t>
                </a:r>
              </a:p>
            </p:txBody>
          </p:sp>
        </p:grpSp>
        <p:sp>
          <p:nvSpPr>
            <p:cNvPr id="2615" name="CuadroTexto 2614">
              <a:extLst>
                <a:ext uri="{FF2B5EF4-FFF2-40B4-BE49-F238E27FC236}">
                  <a16:creationId xmlns:a16="http://schemas.microsoft.com/office/drawing/2014/main" id="{8420F2A8-9368-712C-2784-E38B3B313787}"/>
                </a:ext>
              </a:extLst>
            </p:cNvPr>
            <p:cNvSpPr txBox="1"/>
            <p:nvPr/>
          </p:nvSpPr>
          <p:spPr>
            <a:xfrm>
              <a:off x="3429549" y="3372088"/>
              <a:ext cx="35779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err="1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KDa</a:t>
              </a:r>
              <a:endParaRPr lang="es-ES" sz="700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2600" name="Grupo 2599">
              <a:extLst>
                <a:ext uri="{FF2B5EF4-FFF2-40B4-BE49-F238E27FC236}">
                  <a16:creationId xmlns:a16="http://schemas.microsoft.com/office/drawing/2014/main" id="{FE5F15FD-56F4-9BEF-8843-240E46D64B1F}"/>
                </a:ext>
              </a:extLst>
            </p:cNvPr>
            <p:cNvGrpSpPr/>
            <p:nvPr/>
          </p:nvGrpSpPr>
          <p:grpSpPr>
            <a:xfrm>
              <a:off x="3475382" y="2304992"/>
              <a:ext cx="284052" cy="459848"/>
              <a:chOff x="3859899" y="823846"/>
              <a:chExt cx="284052" cy="459848"/>
            </a:xfrm>
          </p:grpSpPr>
          <p:sp>
            <p:nvSpPr>
              <p:cNvPr id="2602" name="CuadroTexto 2601">
                <a:extLst>
                  <a:ext uri="{FF2B5EF4-FFF2-40B4-BE49-F238E27FC236}">
                    <a16:creationId xmlns:a16="http://schemas.microsoft.com/office/drawing/2014/main" id="{EF303AF1-73D3-D6EB-0E0D-E489EE393CD9}"/>
                  </a:ext>
                </a:extLst>
              </p:cNvPr>
              <p:cNvSpPr txBox="1"/>
              <p:nvPr/>
            </p:nvSpPr>
            <p:spPr>
              <a:xfrm>
                <a:off x="3859899" y="823846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75</a:t>
                </a:r>
              </a:p>
            </p:txBody>
          </p:sp>
          <p:sp>
            <p:nvSpPr>
              <p:cNvPr id="2603" name="CuadroTexto 2602">
                <a:extLst>
                  <a:ext uri="{FF2B5EF4-FFF2-40B4-BE49-F238E27FC236}">
                    <a16:creationId xmlns:a16="http://schemas.microsoft.com/office/drawing/2014/main" id="{3121C709-7B7F-F4EA-2408-BDE4B9D21036}"/>
                  </a:ext>
                </a:extLst>
              </p:cNvPr>
              <p:cNvSpPr txBox="1"/>
              <p:nvPr/>
            </p:nvSpPr>
            <p:spPr>
              <a:xfrm>
                <a:off x="3859899" y="950803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50</a:t>
                </a:r>
              </a:p>
            </p:txBody>
          </p:sp>
          <p:sp>
            <p:nvSpPr>
              <p:cNvPr id="2604" name="CuadroTexto 2603">
                <a:extLst>
                  <a:ext uri="{FF2B5EF4-FFF2-40B4-BE49-F238E27FC236}">
                    <a16:creationId xmlns:a16="http://schemas.microsoft.com/office/drawing/2014/main" id="{8AC20314-E187-32DF-9C4C-D8A97241CBBE}"/>
                  </a:ext>
                </a:extLst>
              </p:cNvPr>
              <p:cNvSpPr txBox="1"/>
              <p:nvPr/>
            </p:nvSpPr>
            <p:spPr>
              <a:xfrm>
                <a:off x="3859899" y="1083639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37</a:t>
                </a:r>
              </a:p>
            </p:txBody>
          </p:sp>
        </p:grpSp>
        <p:sp>
          <p:nvSpPr>
            <p:cNvPr id="2601" name="CuadroTexto 2600">
              <a:extLst>
                <a:ext uri="{FF2B5EF4-FFF2-40B4-BE49-F238E27FC236}">
                  <a16:creationId xmlns:a16="http://schemas.microsoft.com/office/drawing/2014/main" id="{4418FFC3-B8DE-F623-2C47-DD22285BFE76}"/>
                </a:ext>
              </a:extLst>
            </p:cNvPr>
            <p:cNvSpPr txBox="1"/>
            <p:nvPr/>
          </p:nvSpPr>
          <p:spPr>
            <a:xfrm>
              <a:off x="3422084" y="2017496"/>
              <a:ext cx="35779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err="1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KDa</a:t>
              </a:r>
              <a:endParaRPr lang="es-ES" sz="700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2587" name="Grupo 2586">
              <a:extLst>
                <a:ext uri="{FF2B5EF4-FFF2-40B4-BE49-F238E27FC236}">
                  <a16:creationId xmlns:a16="http://schemas.microsoft.com/office/drawing/2014/main" id="{4C387F59-0650-B35B-6D8B-9681AE7B2ACF}"/>
                </a:ext>
              </a:extLst>
            </p:cNvPr>
            <p:cNvGrpSpPr/>
            <p:nvPr/>
          </p:nvGrpSpPr>
          <p:grpSpPr>
            <a:xfrm>
              <a:off x="243339" y="2405849"/>
              <a:ext cx="284052" cy="459848"/>
              <a:chOff x="3859899" y="823846"/>
              <a:chExt cx="284052" cy="459848"/>
            </a:xfrm>
          </p:grpSpPr>
          <p:sp>
            <p:nvSpPr>
              <p:cNvPr id="2589" name="CuadroTexto 2588">
                <a:extLst>
                  <a:ext uri="{FF2B5EF4-FFF2-40B4-BE49-F238E27FC236}">
                    <a16:creationId xmlns:a16="http://schemas.microsoft.com/office/drawing/2014/main" id="{69A5F5F9-9909-4AB1-673B-F17ADE2D31E0}"/>
                  </a:ext>
                </a:extLst>
              </p:cNvPr>
              <p:cNvSpPr txBox="1"/>
              <p:nvPr/>
            </p:nvSpPr>
            <p:spPr>
              <a:xfrm>
                <a:off x="3859899" y="823846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75</a:t>
                </a:r>
              </a:p>
            </p:txBody>
          </p:sp>
          <p:sp>
            <p:nvSpPr>
              <p:cNvPr id="2590" name="CuadroTexto 2589">
                <a:extLst>
                  <a:ext uri="{FF2B5EF4-FFF2-40B4-BE49-F238E27FC236}">
                    <a16:creationId xmlns:a16="http://schemas.microsoft.com/office/drawing/2014/main" id="{955C66DD-20B7-16F6-92C6-50BF1E41AE2A}"/>
                  </a:ext>
                </a:extLst>
              </p:cNvPr>
              <p:cNvSpPr txBox="1"/>
              <p:nvPr/>
            </p:nvSpPr>
            <p:spPr>
              <a:xfrm>
                <a:off x="3859899" y="950803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50</a:t>
                </a:r>
              </a:p>
            </p:txBody>
          </p:sp>
          <p:sp>
            <p:nvSpPr>
              <p:cNvPr id="2591" name="CuadroTexto 2590">
                <a:extLst>
                  <a:ext uri="{FF2B5EF4-FFF2-40B4-BE49-F238E27FC236}">
                    <a16:creationId xmlns:a16="http://schemas.microsoft.com/office/drawing/2014/main" id="{E8142825-92D4-605B-0680-E449FD1DEFD4}"/>
                  </a:ext>
                </a:extLst>
              </p:cNvPr>
              <p:cNvSpPr txBox="1"/>
              <p:nvPr/>
            </p:nvSpPr>
            <p:spPr>
              <a:xfrm>
                <a:off x="3859899" y="1083639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37</a:t>
                </a:r>
              </a:p>
            </p:txBody>
          </p:sp>
        </p:grpSp>
        <p:sp>
          <p:nvSpPr>
            <p:cNvPr id="2588" name="CuadroTexto 2587">
              <a:extLst>
                <a:ext uri="{FF2B5EF4-FFF2-40B4-BE49-F238E27FC236}">
                  <a16:creationId xmlns:a16="http://schemas.microsoft.com/office/drawing/2014/main" id="{2AAFC5FB-03C2-A03D-D872-95BAC81D0E90}"/>
                </a:ext>
              </a:extLst>
            </p:cNvPr>
            <p:cNvSpPr txBox="1"/>
            <p:nvPr/>
          </p:nvSpPr>
          <p:spPr>
            <a:xfrm>
              <a:off x="190041" y="2017496"/>
              <a:ext cx="35779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err="1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KDa</a:t>
              </a:r>
              <a:endParaRPr lang="es-ES" sz="700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8" name="Rectángulo 7">
              <a:extLst>
                <a:ext uri="{FF2B5EF4-FFF2-40B4-BE49-F238E27FC236}">
                  <a16:creationId xmlns:a16="http://schemas.microsoft.com/office/drawing/2014/main" id="{C69446B8-A359-F682-A48C-0DC0733B0FA9}"/>
                </a:ext>
              </a:extLst>
            </p:cNvPr>
            <p:cNvSpPr/>
            <p:nvPr/>
          </p:nvSpPr>
          <p:spPr>
            <a:xfrm>
              <a:off x="5369902" y="1082832"/>
              <a:ext cx="782615" cy="200055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9" name="Rectángulo 8">
              <a:extLst>
                <a:ext uri="{FF2B5EF4-FFF2-40B4-BE49-F238E27FC236}">
                  <a16:creationId xmlns:a16="http://schemas.microsoft.com/office/drawing/2014/main" id="{9D1FEDA3-A3A5-E7BD-6DF5-DE63BD10FEEA}"/>
                </a:ext>
              </a:extLst>
            </p:cNvPr>
            <p:cNvSpPr/>
            <p:nvPr/>
          </p:nvSpPr>
          <p:spPr>
            <a:xfrm>
              <a:off x="2149314" y="1295833"/>
              <a:ext cx="782615" cy="200055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0" name="Rectángulo 9">
              <a:extLst>
                <a:ext uri="{FF2B5EF4-FFF2-40B4-BE49-F238E27FC236}">
                  <a16:creationId xmlns:a16="http://schemas.microsoft.com/office/drawing/2014/main" id="{91BFDDAA-DFBB-33D7-77DD-58FD0F3DCE32}"/>
                </a:ext>
              </a:extLst>
            </p:cNvPr>
            <p:cNvSpPr/>
            <p:nvPr/>
          </p:nvSpPr>
          <p:spPr>
            <a:xfrm>
              <a:off x="2126162" y="2597698"/>
              <a:ext cx="782615" cy="200055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1" name="Rectángulo 10">
              <a:extLst>
                <a:ext uri="{FF2B5EF4-FFF2-40B4-BE49-F238E27FC236}">
                  <a16:creationId xmlns:a16="http://schemas.microsoft.com/office/drawing/2014/main" id="{CC77F6DE-49D3-BD09-60CA-AF2571A7B226}"/>
                </a:ext>
              </a:extLst>
            </p:cNvPr>
            <p:cNvSpPr/>
            <p:nvPr/>
          </p:nvSpPr>
          <p:spPr>
            <a:xfrm>
              <a:off x="5282091" y="2477215"/>
              <a:ext cx="782615" cy="200055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2" name="Rectángulo 11">
              <a:extLst>
                <a:ext uri="{FF2B5EF4-FFF2-40B4-BE49-F238E27FC236}">
                  <a16:creationId xmlns:a16="http://schemas.microsoft.com/office/drawing/2014/main" id="{86ACA1E2-E2FB-B222-4450-6A8BDA2B11D3}"/>
                </a:ext>
              </a:extLst>
            </p:cNvPr>
            <p:cNvSpPr/>
            <p:nvPr/>
          </p:nvSpPr>
          <p:spPr>
            <a:xfrm>
              <a:off x="2193397" y="3929115"/>
              <a:ext cx="782615" cy="200055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3" name="Rectángulo 12">
              <a:extLst>
                <a:ext uri="{FF2B5EF4-FFF2-40B4-BE49-F238E27FC236}">
                  <a16:creationId xmlns:a16="http://schemas.microsoft.com/office/drawing/2014/main" id="{BF1E1E78-773F-282E-2DC5-CAFC6841AA30}"/>
                </a:ext>
              </a:extLst>
            </p:cNvPr>
            <p:cNvSpPr/>
            <p:nvPr/>
          </p:nvSpPr>
          <p:spPr>
            <a:xfrm>
              <a:off x="5408977" y="3848039"/>
              <a:ext cx="782615" cy="200055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4" name="CuadroTexto 13">
              <a:extLst>
                <a:ext uri="{FF2B5EF4-FFF2-40B4-BE49-F238E27FC236}">
                  <a16:creationId xmlns:a16="http://schemas.microsoft.com/office/drawing/2014/main" id="{F7E0C3C2-7F16-6177-D8A6-E1CB5DECBF2B}"/>
                </a:ext>
              </a:extLst>
            </p:cNvPr>
            <p:cNvSpPr txBox="1"/>
            <p:nvPr/>
          </p:nvSpPr>
          <p:spPr>
            <a:xfrm>
              <a:off x="209609" y="3006743"/>
              <a:ext cx="2674964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CB</a:t>
              </a:r>
              <a:r>
                <a:rPr lang="es-ES" sz="750" baseline="-25000" dirty="0">
                  <a:latin typeface="Helvetica" panose="020B0604020202020204" pitchFamily="34" charset="0"/>
                  <a:cs typeface="Helvetica" panose="020B0604020202020204" pitchFamily="34" charset="0"/>
                </a:rPr>
                <a:t>1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R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hippocampa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xtracts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from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Glu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-CRBN-WT/KO and CB</a:t>
              </a:r>
              <a:r>
                <a:rPr lang="es-ES" sz="750" baseline="-25000" dirty="0">
                  <a:latin typeface="Helvetica" panose="020B0604020202020204" pitchFamily="34" charset="0"/>
                  <a:cs typeface="Helvetica" panose="020B0604020202020204" pitchFamily="34" charset="0"/>
                </a:rPr>
                <a:t>1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R-KO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mic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5" name="CuadroTexto 14">
              <a:extLst>
                <a:ext uri="{FF2B5EF4-FFF2-40B4-BE49-F238E27FC236}">
                  <a16:creationId xmlns:a16="http://schemas.microsoft.com/office/drawing/2014/main" id="{201CE3A1-200A-CC34-54A3-6FCE713C6956}"/>
                </a:ext>
              </a:extLst>
            </p:cNvPr>
            <p:cNvSpPr txBox="1"/>
            <p:nvPr/>
          </p:nvSpPr>
          <p:spPr>
            <a:xfrm>
              <a:off x="209608" y="4363810"/>
              <a:ext cx="2804399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CB</a:t>
              </a:r>
              <a:r>
                <a:rPr lang="es-ES" sz="750" baseline="-25000" dirty="0">
                  <a:latin typeface="Helvetica" panose="020B0604020202020204" pitchFamily="34" charset="0"/>
                  <a:cs typeface="Helvetica" panose="020B0604020202020204" pitchFamily="34" charset="0"/>
                </a:rPr>
                <a:t>1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R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hippocampa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xtracts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from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GABA-CRBN-WT/KO and CB</a:t>
              </a:r>
              <a:r>
                <a:rPr lang="es-ES" sz="750" baseline="-25000" dirty="0">
                  <a:latin typeface="Helvetica" panose="020B0604020202020204" pitchFamily="34" charset="0"/>
                  <a:cs typeface="Helvetica" panose="020B0604020202020204" pitchFamily="34" charset="0"/>
                </a:rPr>
                <a:t>1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R-KO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mic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6" name="CuadroTexto 15">
              <a:extLst>
                <a:ext uri="{FF2B5EF4-FFF2-40B4-BE49-F238E27FC236}">
                  <a16:creationId xmlns:a16="http://schemas.microsoft.com/office/drawing/2014/main" id="{788656F0-61BE-04FF-BD32-022699997E24}"/>
                </a:ext>
              </a:extLst>
            </p:cNvPr>
            <p:cNvSpPr txBox="1"/>
            <p:nvPr/>
          </p:nvSpPr>
          <p:spPr>
            <a:xfrm>
              <a:off x="3431311" y="4363810"/>
              <a:ext cx="2914494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Tubulin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hippocampa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xtracts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from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GABA-CRBN-WT/KO and CB</a:t>
              </a:r>
              <a:r>
                <a:rPr lang="es-ES" sz="750" baseline="-25000" dirty="0">
                  <a:latin typeface="Helvetica" panose="020B0604020202020204" pitchFamily="34" charset="0"/>
                  <a:cs typeface="Helvetica" panose="020B0604020202020204" pitchFamily="34" charset="0"/>
                </a:rPr>
                <a:t>1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R-KO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mic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7" name="CuadroTexto 16">
              <a:extLst>
                <a:ext uri="{FF2B5EF4-FFF2-40B4-BE49-F238E27FC236}">
                  <a16:creationId xmlns:a16="http://schemas.microsoft.com/office/drawing/2014/main" id="{9F7127FD-A260-CD52-7A25-88480D36CE20}"/>
                </a:ext>
              </a:extLst>
            </p:cNvPr>
            <p:cNvSpPr txBox="1"/>
            <p:nvPr/>
          </p:nvSpPr>
          <p:spPr>
            <a:xfrm>
              <a:off x="3431310" y="3006743"/>
              <a:ext cx="276028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Tubulin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hippocampa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xtracts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from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Glu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-CRBN-WT/KO and CB</a:t>
              </a:r>
              <a:r>
                <a:rPr lang="es-ES" sz="750" baseline="-25000" dirty="0">
                  <a:latin typeface="Helvetica" panose="020B0604020202020204" pitchFamily="34" charset="0"/>
                  <a:cs typeface="Helvetica" panose="020B0604020202020204" pitchFamily="34" charset="0"/>
                </a:rPr>
                <a:t>1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R-KO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mic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00487395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60</TotalTime>
  <Words>95</Words>
  <Application>Microsoft Office PowerPoint</Application>
  <PresentationFormat>A4 (210 x 297 mm)</PresentationFormat>
  <Paragraphs>3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ARLOS COSTAS INSUA</dc:creator>
  <cp:lastModifiedBy>MANUEL GUZMAN PASTOR</cp:lastModifiedBy>
  <cp:revision>4</cp:revision>
  <dcterms:created xsi:type="dcterms:W3CDTF">2023-12-26T11:36:59Z</dcterms:created>
  <dcterms:modified xsi:type="dcterms:W3CDTF">2024-02-26T07:47:19Z</dcterms:modified>
</cp:coreProperties>
</file>